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81" r:id="rId1"/>
    <p:sldMasterId id="2147483893" r:id="rId2"/>
  </p:sldMasterIdLst>
  <p:notesMasterIdLst>
    <p:notesMasterId r:id="rId9"/>
  </p:notesMasterIdLst>
  <p:sldIdLst>
    <p:sldId id="1490" r:id="rId3"/>
    <p:sldId id="289" r:id="rId4"/>
    <p:sldId id="1480" r:id="rId5"/>
    <p:sldId id="1481" r:id="rId6"/>
    <p:sldId id="1484" r:id="rId7"/>
    <p:sldId id="1479" r:id="rId8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CC"/>
    <a:srgbClr val="EC6538"/>
    <a:srgbClr val="33CC33"/>
    <a:srgbClr val="CCFFFF"/>
    <a:srgbClr val="66FFFF"/>
    <a:srgbClr val="99FF33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6152D0-6B87-4CE5-A338-E708554AD1AB}" v="336" dt="2025-09-26T08:20:24.46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765" autoAdjust="0"/>
    <p:restoredTop sz="92289" autoAdjust="0"/>
  </p:normalViewPr>
  <p:slideViewPr>
    <p:cSldViewPr snapToGrid="0">
      <p:cViewPr>
        <p:scale>
          <a:sx n="100" d="100"/>
          <a:sy n="100" d="100"/>
        </p:scale>
        <p:origin x="1506" y="312"/>
      </p:cViewPr>
      <p:guideLst>
        <p:guide orient="horz" pos="218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祐 本多" userId="b23d2cae5d7aefee" providerId="LiveId" clId="{E521F0EB-A109-473D-BD0C-C269D8D6A082}"/>
    <pc:docChg chg="custSel addSld delSld modSld sldOrd delMainMaster">
      <pc:chgData name="祐 本多" userId="b23d2cae5d7aefee" providerId="LiveId" clId="{E521F0EB-A109-473D-BD0C-C269D8D6A082}" dt="2025-08-20T05:06:19.256" v="61" actId="1036"/>
      <pc:docMkLst>
        <pc:docMk/>
      </pc:docMkLst>
      <pc:sldChg chg="del">
        <pc:chgData name="祐 本多" userId="b23d2cae5d7aefee" providerId="LiveId" clId="{E521F0EB-A109-473D-BD0C-C269D8D6A082}" dt="2025-08-19T07:45:33.622" v="7" actId="47"/>
        <pc:sldMkLst>
          <pc:docMk/>
          <pc:sldMk cId="1659334133" sldId="286"/>
        </pc:sldMkLst>
      </pc:sldChg>
      <pc:sldChg chg="del">
        <pc:chgData name="祐 本多" userId="b23d2cae5d7aefee" providerId="LiveId" clId="{E521F0EB-A109-473D-BD0C-C269D8D6A082}" dt="2025-08-19T07:45:34.563" v="8" actId="47"/>
        <pc:sldMkLst>
          <pc:docMk/>
          <pc:sldMk cId="1798802707" sldId="287"/>
        </pc:sldMkLst>
      </pc:sldChg>
      <pc:sldChg chg="modSp add del mod ord modTransition">
        <pc:chgData name="祐 本多" userId="b23d2cae5d7aefee" providerId="LiveId" clId="{E521F0EB-A109-473D-BD0C-C269D8D6A082}" dt="2025-08-20T05:06:19.256" v="61" actId="1036"/>
        <pc:sldMkLst>
          <pc:docMk/>
          <pc:sldMk cId="604144272" sldId="289"/>
        </pc:sldMkLst>
      </pc:sldChg>
      <pc:sldChg chg="modSp del mod">
        <pc:chgData name="祐 本多" userId="b23d2cae5d7aefee" providerId="LiveId" clId="{E521F0EB-A109-473D-BD0C-C269D8D6A082}" dt="2025-08-19T10:50:19.990" v="12" actId="47"/>
        <pc:sldMkLst>
          <pc:docMk/>
          <pc:sldMk cId="3583044881" sldId="1475"/>
        </pc:sldMkLst>
      </pc:sldChg>
      <pc:sldChg chg="modSp add del mod modShow">
        <pc:chgData name="祐 本多" userId="b23d2cae5d7aefee" providerId="LiveId" clId="{E521F0EB-A109-473D-BD0C-C269D8D6A082}" dt="2025-08-20T05:05:55.200" v="52" actId="404"/>
        <pc:sldMkLst>
          <pc:docMk/>
          <pc:sldMk cId="783998351" sldId="1479"/>
        </pc:sldMkLst>
      </pc:sldChg>
      <pc:sldMasterChg chg="del delSldLayout">
        <pc:chgData name="祐 本多" userId="b23d2cae5d7aefee" providerId="LiveId" clId="{E521F0EB-A109-473D-BD0C-C269D8D6A082}" dt="2025-08-19T10:50:19.990" v="12" actId="47"/>
        <pc:sldMasterMkLst>
          <pc:docMk/>
          <pc:sldMasterMk cId="3291981726" sldId="2147483905"/>
        </pc:sldMasterMkLst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1873723814" sldId="2147483906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2995727293" sldId="2147483907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3015829633" sldId="2147483908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959574573" sldId="2147483909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960121871" sldId="2147483910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1213220593" sldId="2147483911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36650112" sldId="2147483912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3545050716" sldId="2147483913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612912907" sldId="2147483914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1860083057" sldId="2147483915"/>
          </pc:sldLayoutMkLst>
        </pc:sldLayoutChg>
        <pc:sldLayoutChg chg="del">
          <pc:chgData name="祐 本多" userId="b23d2cae5d7aefee" providerId="LiveId" clId="{E521F0EB-A109-473D-BD0C-C269D8D6A082}" dt="2025-08-19T10:50:19.990" v="12" actId="47"/>
          <pc:sldLayoutMkLst>
            <pc:docMk/>
            <pc:sldMasterMk cId="3291981726" sldId="2147483905"/>
            <pc:sldLayoutMk cId="1343956189" sldId="2147483916"/>
          </pc:sldLayoutMkLst>
        </pc:sldLayoutChg>
      </pc:sldMasterChg>
    </pc:docChg>
  </pc:docChgLst>
  <pc:docChgLst>
    <pc:chgData name="祐 本多" userId="b23d2cae5d7aefee" providerId="LiveId" clId="{3CFBA0B2-0CBE-4E28-86CB-431CF2756798}"/>
    <pc:docChg chg="undo custSel addSld delSld modSld sldOrd">
      <pc:chgData name="祐 本多" userId="b23d2cae5d7aefee" providerId="LiveId" clId="{3CFBA0B2-0CBE-4E28-86CB-431CF2756798}" dt="2025-09-26T08:20:30.929" v="5927" actId="47"/>
      <pc:docMkLst>
        <pc:docMk/>
      </pc:docMkLst>
      <pc:sldChg chg="addSp modSp mod">
        <pc:chgData name="祐 本多" userId="b23d2cae5d7aefee" providerId="LiveId" clId="{3CFBA0B2-0CBE-4E28-86CB-431CF2756798}" dt="2025-09-26T07:48:34.811" v="5877" actId="20577"/>
        <pc:sldMkLst>
          <pc:docMk/>
          <pc:sldMk cId="604144272" sldId="289"/>
        </pc:sldMkLst>
        <pc:spChg chg="mod">
          <ac:chgData name="祐 本多" userId="b23d2cae5d7aefee" providerId="LiveId" clId="{3CFBA0B2-0CBE-4E28-86CB-431CF2756798}" dt="2025-09-26T07:39:36.902" v="5844" actId="1037"/>
          <ac:spMkLst>
            <pc:docMk/>
            <pc:sldMk cId="604144272" sldId="289"/>
            <ac:spMk id="7" creationId="{584FFB07-DABF-0D82-6EB2-013697EEDB6F}"/>
          </ac:spMkLst>
        </pc:spChg>
        <pc:spChg chg="mod">
          <ac:chgData name="祐 本多" userId="b23d2cae5d7aefee" providerId="LiveId" clId="{3CFBA0B2-0CBE-4E28-86CB-431CF2756798}" dt="2025-09-21T07:04:32.217" v="4171" actId="1037"/>
          <ac:spMkLst>
            <pc:docMk/>
            <pc:sldMk cId="604144272" sldId="289"/>
            <ac:spMk id="8" creationId="{5F2D7BD5-3C67-897A-D2E6-4A73C308498C}"/>
          </ac:spMkLst>
        </pc:spChg>
        <pc:graphicFrameChg chg="mod modGraphic">
          <ac:chgData name="祐 本多" userId="b23d2cae5d7aefee" providerId="LiveId" clId="{3CFBA0B2-0CBE-4E28-86CB-431CF2756798}" dt="2025-09-26T07:48:34.811" v="5877" actId="20577"/>
          <ac:graphicFrameMkLst>
            <pc:docMk/>
            <pc:sldMk cId="604144272" sldId="289"/>
            <ac:graphicFrameMk id="6" creationId="{8DC5524F-F0A8-D7B2-19F7-823566A41F2F}"/>
          </ac:graphicFrameMkLst>
        </pc:graphicFrameChg>
      </pc:sldChg>
      <pc:sldChg chg="modSp mod ord">
        <pc:chgData name="祐 本多" userId="b23d2cae5d7aefee" providerId="LiveId" clId="{3CFBA0B2-0CBE-4E28-86CB-431CF2756798}" dt="2025-09-23T05:12:42.923" v="5822"/>
        <pc:sldMkLst>
          <pc:docMk/>
          <pc:sldMk cId="783998351" sldId="1479"/>
        </pc:sldMkLst>
        <pc:spChg chg="mod">
          <ac:chgData name="祐 本多" userId="b23d2cae5d7aefee" providerId="LiveId" clId="{3CFBA0B2-0CBE-4E28-86CB-431CF2756798}" dt="2025-09-21T05:21:45.515" v="2927" actId="20577"/>
          <ac:spMkLst>
            <pc:docMk/>
            <pc:sldMk cId="783998351" sldId="1479"/>
            <ac:spMk id="7" creationId="{ED3172C6-F39A-7E44-79C1-A9E1C45599E2}"/>
          </ac:spMkLst>
        </pc:spChg>
      </pc:sldChg>
      <pc:sldChg chg="modSp add mod">
        <pc:chgData name="祐 本多" userId="b23d2cae5d7aefee" providerId="LiveId" clId="{3CFBA0B2-0CBE-4E28-86CB-431CF2756798}" dt="2025-09-26T08:09:08.572" v="5889" actId="20577"/>
        <pc:sldMkLst>
          <pc:docMk/>
          <pc:sldMk cId="3117893198" sldId="1480"/>
        </pc:sldMkLst>
        <pc:spChg chg="mod">
          <ac:chgData name="祐 本多" userId="b23d2cae5d7aefee" providerId="LiveId" clId="{3CFBA0B2-0CBE-4E28-86CB-431CF2756798}" dt="2025-09-20T08:50:01.957" v="899" actId="404"/>
          <ac:spMkLst>
            <pc:docMk/>
            <pc:sldMk cId="3117893198" sldId="1480"/>
            <ac:spMk id="7" creationId="{62D7001A-90F9-1804-2D0C-543C93771C11}"/>
          </ac:spMkLst>
        </pc:spChg>
        <pc:spChg chg="mod">
          <ac:chgData name="祐 本多" userId="b23d2cae5d7aefee" providerId="LiveId" clId="{3CFBA0B2-0CBE-4E28-86CB-431CF2756798}" dt="2025-09-21T04:59:11.986" v="2788" actId="1036"/>
          <ac:spMkLst>
            <pc:docMk/>
            <pc:sldMk cId="3117893198" sldId="1480"/>
            <ac:spMk id="8" creationId="{D683B5E1-739B-6DFF-CBDF-CE0674057024}"/>
          </ac:spMkLst>
        </pc:spChg>
        <pc:graphicFrameChg chg="mod modGraphic">
          <ac:chgData name="祐 本多" userId="b23d2cae5d7aefee" providerId="LiveId" clId="{3CFBA0B2-0CBE-4E28-86CB-431CF2756798}" dt="2025-09-26T08:09:08.572" v="5889" actId="20577"/>
          <ac:graphicFrameMkLst>
            <pc:docMk/>
            <pc:sldMk cId="3117893198" sldId="1480"/>
            <ac:graphicFrameMk id="6" creationId="{5C9FBBCD-AE81-8AB2-2FD6-919261DC279E}"/>
          </ac:graphicFrameMkLst>
        </pc:graphicFrameChg>
      </pc:sldChg>
      <pc:sldChg chg="modSp add mod">
        <pc:chgData name="祐 本多" userId="b23d2cae5d7aefee" providerId="LiveId" clId="{3CFBA0B2-0CBE-4E28-86CB-431CF2756798}" dt="2025-09-26T08:13:47.539" v="5912" actId="20577"/>
        <pc:sldMkLst>
          <pc:docMk/>
          <pc:sldMk cId="3953337881" sldId="1481"/>
        </pc:sldMkLst>
        <pc:spChg chg="mod">
          <ac:chgData name="祐 本多" userId="b23d2cae5d7aefee" providerId="LiveId" clId="{3CFBA0B2-0CBE-4E28-86CB-431CF2756798}" dt="2025-09-18T12:33:40.408" v="334" actId="1076"/>
          <ac:spMkLst>
            <pc:docMk/>
            <pc:sldMk cId="3953337881" sldId="1481"/>
            <ac:spMk id="7" creationId="{DABE5173-7BA7-A574-D9C3-4999976AF647}"/>
          </ac:spMkLst>
        </pc:spChg>
        <pc:spChg chg="mod">
          <ac:chgData name="祐 本多" userId="b23d2cae5d7aefee" providerId="LiveId" clId="{3CFBA0B2-0CBE-4E28-86CB-431CF2756798}" dt="2025-09-21T05:10:41.269" v="2916" actId="1035"/>
          <ac:spMkLst>
            <pc:docMk/>
            <pc:sldMk cId="3953337881" sldId="1481"/>
            <ac:spMk id="8" creationId="{D5858132-A6C2-68CE-7199-33C043CC0C41}"/>
          </ac:spMkLst>
        </pc:spChg>
        <pc:graphicFrameChg chg="mod modGraphic">
          <ac:chgData name="祐 本多" userId="b23d2cae5d7aefee" providerId="LiveId" clId="{3CFBA0B2-0CBE-4E28-86CB-431CF2756798}" dt="2025-09-26T08:13:47.539" v="5912" actId="20577"/>
          <ac:graphicFrameMkLst>
            <pc:docMk/>
            <pc:sldMk cId="3953337881" sldId="1481"/>
            <ac:graphicFrameMk id="6" creationId="{928002C7-F42A-D4DB-EDBD-4759BB801F3A}"/>
          </ac:graphicFrameMkLst>
        </pc:graphicFrameChg>
      </pc:sldChg>
      <pc:sldChg chg="addSp delSp modSp new del mod">
        <pc:chgData name="祐 本多" userId="b23d2cae5d7aefee" providerId="LiveId" clId="{3CFBA0B2-0CBE-4E28-86CB-431CF2756798}" dt="2025-09-22T23:33:34.601" v="4335" actId="47"/>
        <pc:sldMkLst>
          <pc:docMk/>
          <pc:sldMk cId="3706801030" sldId="1482"/>
        </pc:sldMkLst>
      </pc:sldChg>
      <pc:sldChg chg="addSp delSp modSp add del mod">
        <pc:chgData name="祐 本多" userId="b23d2cae5d7aefee" providerId="LiveId" clId="{3CFBA0B2-0CBE-4E28-86CB-431CF2756798}" dt="2025-09-25T11:09:16.215" v="5826" actId="47"/>
        <pc:sldMkLst>
          <pc:docMk/>
          <pc:sldMk cId="2647293700" sldId="1483"/>
        </pc:sldMkLst>
      </pc:sldChg>
      <pc:sldChg chg="modSp add mod ord">
        <pc:chgData name="祐 本多" userId="b23d2cae5d7aefee" providerId="LiveId" clId="{3CFBA0B2-0CBE-4E28-86CB-431CF2756798}" dt="2025-09-23T05:12:42.923" v="5822"/>
        <pc:sldMkLst>
          <pc:docMk/>
          <pc:sldMk cId="2624935603" sldId="1484"/>
        </pc:sldMkLst>
        <pc:spChg chg="mod">
          <ac:chgData name="祐 本多" userId="b23d2cae5d7aefee" providerId="LiveId" clId="{3CFBA0B2-0CBE-4E28-86CB-431CF2756798}" dt="2025-09-22T23:45:29.737" v="4765" actId="20577"/>
          <ac:spMkLst>
            <pc:docMk/>
            <pc:sldMk cId="2624935603" sldId="1484"/>
            <ac:spMk id="4" creationId="{13ADD121-9F0B-6BEC-EF70-0B883F34AF31}"/>
          </ac:spMkLst>
        </pc:spChg>
        <pc:spChg chg="mod">
          <ac:chgData name="祐 本多" userId="b23d2cae5d7aefee" providerId="LiveId" clId="{3CFBA0B2-0CBE-4E28-86CB-431CF2756798}" dt="2025-09-23T00:04:50.824" v="5243" actId="1076"/>
          <ac:spMkLst>
            <pc:docMk/>
            <pc:sldMk cId="2624935603" sldId="1484"/>
            <ac:spMk id="49" creationId="{3EF3E72C-5FC8-83D6-F742-5636E803AAE8}"/>
          </ac:spMkLst>
        </pc:spChg>
      </pc:sldChg>
      <pc:sldChg chg="addSp add del">
        <pc:chgData name="祐 本多" userId="b23d2cae5d7aefee" providerId="LiveId" clId="{3CFBA0B2-0CBE-4E28-86CB-431CF2756798}" dt="2025-09-25T11:10:32.457" v="5839" actId="47"/>
        <pc:sldMkLst>
          <pc:docMk/>
          <pc:sldMk cId="1554206419" sldId="1485"/>
        </pc:sldMkLst>
        <pc:picChg chg="add">
          <ac:chgData name="祐 本多" userId="b23d2cae5d7aefee" providerId="LiveId" clId="{3CFBA0B2-0CBE-4E28-86CB-431CF2756798}" dt="2025-09-25T11:09:39.960" v="5827"/>
          <ac:picMkLst>
            <pc:docMk/>
            <pc:sldMk cId="1554206419" sldId="1485"/>
            <ac:picMk id="15" creationId="{1CAB83A8-AC30-7428-CE71-B219CFFD9B0A}"/>
          </ac:picMkLst>
        </pc:picChg>
      </pc:sldChg>
      <pc:sldChg chg="delSp modSp add del mod">
        <pc:chgData name="祐 本多" userId="b23d2cae5d7aefee" providerId="LiveId" clId="{3CFBA0B2-0CBE-4E28-86CB-431CF2756798}" dt="2025-09-25T11:10:20.039" v="5838" actId="47"/>
        <pc:sldMkLst>
          <pc:docMk/>
          <pc:sldMk cId="478736024" sldId="1486"/>
        </pc:sldMkLst>
        <pc:spChg chg="mod">
          <ac:chgData name="祐 本多" userId="b23d2cae5d7aefee" providerId="LiveId" clId="{3CFBA0B2-0CBE-4E28-86CB-431CF2756798}" dt="2025-09-25T11:09:57.419" v="5831" actId="1076"/>
          <ac:spMkLst>
            <pc:docMk/>
            <pc:sldMk cId="478736024" sldId="1486"/>
            <ac:spMk id="49" creationId="{1A600078-D9CB-D384-B5D8-DA76549C755E}"/>
          </ac:spMkLst>
        </pc:spChg>
        <pc:picChg chg="del">
          <ac:chgData name="祐 本多" userId="b23d2cae5d7aefee" providerId="LiveId" clId="{3CFBA0B2-0CBE-4E28-86CB-431CF2756798}" dt="2025-09-25T11:10:08.545" v="5833" actId="21"/>
          <ac:picMkLst>
            <pc:docMk/>
            <pc:sldMk cId="478736024" sldId="1486"/>
            <ac:picMk id="15" creationId="{F791EBA1-4663-2EFE-85E8-3CAC2DAE3FC5}"/>
          </ac:picMkLst>
        </pc:picChg>
      </pc:sldChg>
      <pc:sldChg chg="addSp modSp new del mod setBg">
        <pc:chgData name="祐 本多" userId="b23d2cae5d7aefee" providerId="LiveId" clId="{3CFBA0B2-0CBE-4E28-86CB-431CF2756798}" dt="2025-09-26T08:19:29.965" v="5914" actId="47"/>
        <pc:sldMkLst>
          <pc:docMk/>
          <pc:sldMk cId="3250451240" sldId="1487"/>
        </pc:sldMkLst>
        <pc:spChg chg="add">
          <ac:chgData name="祐 本多" userId="b23d2cae5d7aefee" providerId="LiveId" clId="{3CFBA0B2-0CBE-4E28-86CB-431CF2756798}" dt="2025-09-25T11:10:15.022" v="5835" actId="26606"/>
          <ac:spMkLst>
            <pc:docMk/>
            <pc:sldMk cId="3250451240" sldId="1487"/>
            <ac:spMk id="20" creationId="{42A4FC2C-047E-45A5-965D-8E1E3BF09BC6}"/>
          </ac:spMkLst>
        </pc:spChg>
        <pc:picChg chg="add mod">
          <ac:chgData name="祐 本多" userId="b23d2cae5d7aefee" providerId="LiveId" clId="{3CFBA0B2-0CBE-4E28-86CB-431CF2756798}" dt="2025-09-25T11:10:17.600" v="5837" actId="962"/>
          <ac:picMkLst>
            <pc:docMk/>
            <pc:sldMk cId="3250451240" sldId="1487"/>
            <ac:picMk id="15" creationId="{F791EBA1-4663-2EFE-85E8-3CAC2DAE3FC5}"/>
          </ac:picMkLst>
        </pc:picChg>
      </pc:sldChg>
      <pc:sldChg chg="add del">
        <pc:chgData name="祐 本多" userId="b23d2cae5d7aefee" providerId="LiveId" clId="{3CFBA0B2-0CBE-4E28-86CB-431CF2756798}" dt="2025-09-26T08:19:45.622" v="5916" actId="47"/>
        <pc:sldMkLst>
          <pc:docMk/>
          <pc:sldMk cId="1554206419" sldId="1488"/>
        </pc:sldMkLst>
      </pc:sldChg>
      <pc:sldChg chg="addSp delSp add del mod">
        <pc:chgData name="祐 本多" userId="b23d2cae5d7aefee" providerId="LiveId" clId="{3CFBA0B2-0CBE-4E28-86CB-431CF2756798}" dt="2025-09-26T08:20:30.929" v="5927" actId="47"/>
        <pc:sldMkLst>
          <pc:docMk/>
          <pc:sldMk cId="1099967573" sldId="1489"/>
        </pc:sldMkLst>
        <pc:picChg chg="add del">
          <ac:chgData name="祐 本多" userId="b23d2cae5d7aefee" providerId="LiveId" clId="{3CFBA0B2-0CBE-4E28-86CB-431CF2756798}" dt="2025-09-26T08:20:17" v="5924" actId="21"/>
          <ac:picMkLst>
            <pc:docMk/>
            <pc:sldMk cId="1099967573" sldId="1489"/>
            <ac:picMk id="15" creationId="{B4E52E4B-256A-58F5-C5F2-818B8CE595C8}"/>
          </ac:picMkLst>
        </pc:picChg>
      </pc:sldChg>
      <pc:sldChg chg="addSp modSp new mod setBg">
        <pc:chgData name="祐 本多" userId="b23d2cae5d7aefee" providerId="LiveId" clId="{3CFBA0B2-0CBE-4E28-86CB-431CF2756798}" dt="2025-09-26T08:20:26.686" v="5926" actId="26606"/>
        <pc:sldMkLst>
          <pc:docMk/>
          <pc:sldMk cId="776824434" sldId="1490"/>
        </pc:sldMkLst>
        <pc:spChg chg="add">
          <ac:chgData name="祐 本多" userId="b23d2cae5d7aefee" providerId="LiveId" clId="{3CFBA0B2-0CBE-4E28-86CB-431CF2756798}" dt="2025-09-26T08:20:26.686" v="5926" actId="26606"/>
          <ac:spMkLst>
            <pc:docMk/>
            <pc:sldMk cId="776824434" sldId="1490"/>
            <ac:spMk id="7" creationId="{42A4FC2C-047E-45A5-965D-8E1E3BF09BC6}"/>
          </ac:spMkLst>
        </pc:spChg>
        <pc:picChg chg="add mod">
          <ac:chgData name="祐 本多" userId="b23d2cae5d7aefee" providerId="LiveId" clId="{3CFBA0B2-0CBE-4E28-86CB-431CF2756798}" dt="2025-09-26T08:20:26.686" v="5926" actId="26606"/>
          <ac:picMkLst>
            <pc:docMk/>
            <pc:sldMk cId="776824434" sldId="1490"/>
            <ac:picMk id="2" creationId="{EACF4D16-9D9B-998A-25DD-288F274A56C1}"/>
          </ac:picMkLst>
        </pc:picChg>
      </pc:sldChg>
      <pc:sldChg chg="add del">
        <pc:chgData name="祐 本多" userId="b23d2cae5d7aefee" providerId="LiveId" clId="{3CFBA0B2-0CBE-4E28-86CB-431CF2756798}" dt="2025-09-26T08:20:16.147" v="5923"/>
        <pc:sldMkLst>
          <pc:docMk/>
          <pc:sldMk cId="3944851397" sldId="149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6D3F72-ADA4-437F-B197-5C5A2C81054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AC70B2-FA8B-468B-B80A-8E68A4A801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27053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4530"/>
            <a:ext cx="6858000" cy="2387600"/>
          </a:xfrm>
        </p:spPr>
        <p:txBody>
          <a:bodyPr anchor="b">
            <a:normAutofit/>
          </a:bodyPr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 algn="ctr">
              <a:buNone/>
              <a:defRPr sz="2100"/>
            </a:lvl2pPr>
            <a:lvl3pPr marL="685800" indent="0" algn="ctr">
              <a:buNone/>
              <a:defRPr sz="1800"/>
            </a:lvl3pPr>
            <a:lvl4pPr marL="1028700" indent="0" algn="ctr">
              <a:buNone/>
              <a:defRPr sz="1500"/>
            </a:lvl4pPr>
            <a:lvl5pPr marL="1371600" indent="0" algn="ctr">
              <a:buNone/>
              <a:defRPr sz="1500"/>
            </a:lvl5pPr>
            <a:lvl6pPr marL="1714500" indent="0" algn="ctr">
              <a:buNone/>
              <a:defRPr sz="1500"/>
            </a:lvl6pPr>
            <a:lvl7pPr marL="2057400" indent="0" algn="ctr">
              <a:buNone/>
              <a:defRPr sz="1500"/>
            </a:lvl7pPr>
            <a:lvl8pPr marL="2400300" indent="0" algn="ctr">
              <a:buNone/>
              <a:defRPr sz="1500"/>
            </a:lvl8pPr>
            <a:lvl9pPr marL="2743200" indent="0" algn="ctr">
              <a:buNone/>
              <a:defRPr sz="15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544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5768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0362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0363"/>
            <a:ext cx="5800725" cy="581183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595446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148964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704924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97817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618315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42327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72886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67589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4393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292557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30242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55588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705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12423"/>
            <a:ext cx="7886700" cy="2851208"/>
          </a:xfrm>
        </p:spPr>
        <p:txBody>
          <a:bodyPr anchor="b">
            <a:normAutofit/>
          </a:bodyPr>
          <a:lstStyle>
            <a:lvl1pPr>
              <a:defRPr sz="45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52634"/>
            <a:ext cx="78867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4512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33845" y="1828801"/>
            <a:ext cx="38862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8801"/>
            <a:ext cx="38862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002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845" y="1681851"/>
            <a:ext cx="3867150" cy="825699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3845" y="2507551"/>
            <a:ext cx="3867150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851"/>
            <a:ext cx="3886201" cy="825698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7551"/>
            <a:ext cx="3886201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6983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178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154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936" y="457201"/>
            <a:ext cx="2948940" cy="1600197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6200" y="990600"/>
            <a:ext cx="4629150" cy="4876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936" y="2057399"/>
            <a:ext cx="2948940" cy="3810001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1577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936" y="457200"/>
            <a:ext cx="2948940" cy="1600200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6200" y="990600"/>
            <a:ext cx="4629150" cy="4876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936" y="2057400"/>
            <a:ext cx="2948940" cy="3810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95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33845" y="365760"/>
            <a:ext cx="7886700" cy="13255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845" y="1828801"/>
            <a:ext cx="7886700" cy="43513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13E0F721-706C-4DD3-885B-519AD06E787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63145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AF6E9-7FF6-4EA8-BF0B-AF10FAB32C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290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82" r:id="rId1"/>
    <p:sldLayoutId id="2147483883" r:id="rId2"/>
    <p:sldLayoutId id="2147483884" r:id="rId3"/>
    <p:sldLayoutId id="2147483885" r:id="rId4"/>
    <p:sldLayoutId id="2147483886" r:id="rId5"/>
    <p:sldLayoutId id="2147483887" r:id="rId6"/>
    <p:sldLayoutId id="2147483888" r:id="rId7"/>
    <p:sldLayoutId id="2147483889" r:id="rId8"/>
    <p:sldLayoutId id="2147483890" r:id="rId9"/>
    <p:sldLayoutId id="2147483891" r:id="rId10"/>
    <p:sldLayoutId id="214748389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Wingdings 2" pitchFamily="18" charset="2"/>
        <a:buChar char="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191E42-F44F-450B-B303-EA8A44A07483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64041-53A6-4B82-A5F6-207103520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0053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94" r:id="rId1"/>
    <p:sldLayoutId id="2147483895" r:id="rId2"/>
    <p:sldLayoutId id="2147483896" r:id="rId3"/>
    <p:sldLayoutId id="2147483897" r:id="rId4"/>
    <p:sldLayoutId id="2147483898" r:id="rId5"/>
    <p:sldLayoutId id="2147483899" r:id="rId6"/>
    <p:sldLayoutId id="2147483900" r:id="rId7"/>
    <p:sldLayoutId id="2147483901" r:id="rId8"/>
    <p:sldLayoutId id="2147483902" r:id="rId9"/>
    <p:sldLayoutId id="2147483903" r:id="rId10"/>
    <p:sldLayoutId id="214748390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6.jpeg"/><Relationship Id="rId5" Type="http://schemas.openxmlformats.org/officeDocument/2006/relationships/image" Target="../media/image5.svg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143" y="0"/>
            <a:ext cx="9141714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EACF4D16-9D9B-998A-25DD-288F274A56C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19"/>
          <a:stretch>
            <a:fillRect/>
          </a:stretch>
        </p:blipFill>
        <p:spPr>
          <a:xfrm>
            <a:off x="20" y="1282"/>
            <a:ext cx="9143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68244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8DC5524F-F0A8-D7B2-19F7-823566A41F2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16327532"/>
              </p:ext>
            </p:extLst>
          </p:nvPr>
        </p:nvGraphicFramePr>
        <p:xfrm>
          <a:off x="223162" y="1527162"/>
          <a:ext cx="8790098" cy="3549666"/>
        </p:xfrm>
        <a:graphic>
          <a:graphicData uri="http://schemas.openxmlformats.org/drawingml/2006/table">
            <a:tbl>
              <a:tblPr firstRow="1" firstCol="1" bandRow="1"/>
              <a:tblGrid>
                <a:gridCol w="1292207">
                  <a:extLst>
                    <a:ext uri="{9D8B030D-6E8A-4147-A177-3AD203B41FA5}">
                      <a16:colId xmlns:a16="http://schemas.microsoft.com/office/drawing/2014/main" val="1019398454"/>
                    </a:ext>
                  </a:extLst>
                </a:gridCol>
                <a:gridCol w="1228725">
                  <a:extLst>
                    <a:ext uri="{9D8B030D-6E8A-4147-A177-3AD203B41FA5}">
                      <a16:colId xmlns:a16="http://schemas.microsoft.com/office/drawing/2014/main" val="683041976"/>
                    </a:ext>
                  </a:extLst>
                </a:gridCol>
                <a:gridCol w="1190625">
                  <a:extLst>
                    <a:ext uri="{9D8B030D-6E8A-4147-A177-3AD203B41FA5}">
                      <a16:colId xmlns:a16="http://schemas.microsoft.com/office/drawing/2014/main" val="1773304688"/>
                    </a:ext>
                  </a:extLst>
                </a:gridCol>
                <a:gridCol w="1190625">
                  <a:extLst>
                    <a:ext uri="{9D8B030D-6E8A-4147-A177-3AD203B41FA5}">
                      <a16:colId xmlns:a16="http://schemas.microsoft.com/office/drawing/2014/main" val="1535596634"/>
                    </a:ext>
                  </a:extLst>
                </a:gridCol>
                <a:gridCol w="752475">
                  <a:extLst>
                    <a:ext uri="{9D8B030D-6E8A-4147-A177-3AD203B41FA5}">
                      <a16:colId xmlns:a16="http://schemas.microsoft.com/office/drawing/2014/main" val="324622620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74451462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527971933"/>
                    </a:ext>
                  </a:extLst>
                </a:gridCol>
                <a:gridCol w="849441">
                  <a:extLst>
                    <a:ext uri="{9D8B030D-6E8A-4147-A177-3AD203B41FA5}">
                      <a16:colId xmlns:a16="http://schemas.microsoft.com/office/drawing/2014/main" val="802683437"/>
                    </a:ext>
                  </a:extLst>
                </a:gridCol>
              </a:tblGrid>
              <a:tr h="264907">
                <a:tc>
                  <a:txBody>
                    <a:bodyPr/>
                    <a:lstStyle/>
                    <a:p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Overall</a:t>
                      </a:r>
                      <a:endParaRPr lang="ja-JP" altLang="en-US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alt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261</a:t>
                      </a:r>
                      <a:r>
                        <a:rPr lang="ja-JP" alt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altLang="en-US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200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mplified frailty assessment</a:t>
                      </a:r>
                      <a:endParaRPr lang="en-US" altLang="ja-JP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Standard assessment: J-CHS criteria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8798772"/>
                  </a:ext>
                </a:extLst>
              </a:tr>
              <a:tr h="385723">
                <a:tc>
                  <a:txBody>
                    <a:bodyPr/>
                    <a:lstStyle/>
                    <a:p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63</a:t>
                      </a:r>
                      <a:r>
                        <a:rPr 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on-</a:t>
                      </a: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198</a:t>
                      </a:r>
                      <a:r>
                        <a:rPr 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 value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86</a:t>
                      </a:r>
                      <a:r>
                        <a:rPr 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on-</a:t>
                      </a: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1</a:t>
                      </a: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5</a:t>
                      </a:r>
                      <a:r>
                        <a:rPr 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 value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3791298"/>
                  </a:ext>
                </a:extLst>
              </a:tr>
              <a:tr h="414148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Weight loss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5 (29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6 (41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9 (25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16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7 (55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8 (16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alt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5535830"/>
                  </a:ext>
                </a:extLst>
              </a:tr>
              <a:tr h="414148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Exhaustion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7 (26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4 (70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3 (12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alt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6 (54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1 (12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alt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7361983"/>
                  </a:ext>
                </a:extLst>
              </a:tr>
              <a:tr h="414148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Low activity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56 (60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6 (73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10 (56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18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7(90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9 (45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1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alt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4574325"/>
                  </a:ext>
                </a:extLst>
              </a:tr>
              <a:tr h="414148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buNone/>
                      </a:pPr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Slowness*</a:t>
                      </a:r>
                      <a:endParaRPr lang="ja-JP" sz="16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22 (47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5 (87)</a:t>
                      </a:r>
                      <a:endParaRPr lang="ja-JP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7 (9)</a:t>
                      </a:r>
                      <a:endParaRPr lang="ja-JP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7 (78)</a:t>
                      </a:r>
                      <a:endParaRPr lang="ja-JP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5 (31)</a:t>
                      </a:r>
                      <a:endParaRPr lang="ja-JP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318704"/>
                  </a:ext>
                </a:extLst>
              </a:tr>
              <a:tr h="414148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buNone/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Gait speed (m/s)</a:t>
                      </a:r>
                      <a:endParaRPr lang="ja-JP" sz="16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0 [0.9-1.2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9 [0.8-1.0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1 [0.9-1.2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alt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9 [0.8-1.0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1 [1.0-1.2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7363143"/>
                  </a:ext>
                </a:extLst>
              </a:tr>
              <a:tr h="414148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buNone/>
                      </a:pPr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Weakness**</a:t>
                      </a:r>
                      <a:endParaRPr lang="ja-JP" sz="16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9 (26)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7 (43)</a:t>
                      </a:r>
                      <a:endParaRPr lang="ja-JP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4 (22)</a:t>
                      </a:r>
                      <a:endParaRPr lang="ja-JP" sz="14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</a:t>
                      </a:r>
                      <a:endParaRPr lang="ja-JP" alt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3 (62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6 (9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6389289"/>
                  </a:ext>
                </a:extLst>
              </a:tr>
              <a:tr h="414148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buNone/>
                      </a:pPr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Grip strength (kg)</a:t>
                      </a:r>
                      <a:endParaRPr lang="ja-JP" sz="16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8</a:t>
                      </a: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[20-34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5 [18-31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9 [21-35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1 [16-27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1 [25-36]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4080972"/>
                  </a:ext>
                </a:extLst>
              </a:tr>
            </a:tbl>
          </a:graphicData>
        </a:graphic>
      </p:graphicFrame>
      <p:sp>
        <p:nvSpPr>
          <p:cNvPr id="7" name="タイトル 3">
            <a:extLst>
              <a:ext uri="{FF2B5EF4-FFF2-40B4-BE49-F238E27FC236}">
                <a16:creationId xmlns:a16="http://schemas.microsoft.com/office/drawing/2014/main" id="{584FFB07-DABF-0D82-6EB2-013697EEDB6F}"/>
              </a:ext>
            </a:extLst>
          </p:cNvPr>
          <p:cNvSpPr txBox="1">
            <a:spLocks/>
          </p:cNvSpPr>
          <p:nvPr/>
        </p:nvSpPr>
        <p:spPr>
          <a:xfrm>
            <a:off x="44306" y="487876"/>
            <a:ext cx="9044609" cy="6056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 sz="2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Table</a:t>
            </a: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Frailty Assessment Items (J-CHS Frailty Index)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F2D7BD5-3C67-897A-D2E6-4A73C308498C}"/>
              </a:ext>
            </a:extLst>
          </p:cNvPr>
          <p:cNvSpPr txBox="1"/>
          <p:nvPr/>
        </p:nvSpPr>
        <p:spPr>
          <a:xfrm>
            <a:off x="223162" y="5076828"/>
            <a:ext cx="4806124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ta are presented as the median [interquartile range] or n (%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J-CHS</a:t>
            </a:r>
            <a:r>
              <a:rPr lang="en-US" altLang="ja-JP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Japanese version of the Cardiovascular Health Study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*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it speed &lt;1.0 m/s</a:t>
            </a:r>
            <a:r>
              <a:rPr kumimoji="1" lang="ja-JP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　　　** 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rip strength &lt;28kg (male), &lt;18kg (female) </a:t>
            </a:r>
          </a:p>
        </p:txBody>
      </p:sp>
    </p:spTree>
    <p:extLst>
      <p:ext uri="{BB962C8B-B14F-4D97-AF65-F5344CB8AC3E}">
        <p14:creationId xmlns:p14="http://schemas.microsoft.com/office/powerpoint/2010/main" val="6041442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4577A0B-6E0A-C931-7F72-85238A3E428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5C9FBBCD-AE81-8AB2-2FD6-919261DC279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358135407"/>
              </p:ext>
            </p:extLst>
          </p:nvPr>
        </p:nvGraphicFramePr>
        <p:xfrm>
          <a:off x="177000" y="342777"/>
          <a:ext cx="8815463" cy="6064865"/>
        </p:xfrm>
        <a:graphic>
          <a:graphicData uri="http://schemas.openxmlformats.org/drawingml/2006/table">
            <a:tbl>
              <a:tblPr firstRow="1" firstCol="1" bandRow="1"/>
              <a:tblGrid>
                <a:gridCol w="1844878">
                  <a:extLst>
                    <a:ext uri="{9D8B030D-6E8A-4147-A177-3AD203B41FA5}">
                      <a16:colId xmlns:a16="http://schemas.microsoft.com/office/drawing/2014/main" val="1019398454"/>
                    </a:ext>
                  </a:extLst>
                </a:gridCol>
                <a:gridCol w="1205957">
                  <a:extLst>
                    <a:ext uri="{9D8B030D-6E8A-4147-A177-3AD203B41FA5}">
                      <a16:colId xmlns:a16="http://schemas.microsoft.com/office/drawing/2014/main" val="683041976"/>
                    </a:ext>
                  </a:extLst>
                </a:gridCol>
                <a:gridCol w="1059473">
                  <a:extLst>
                    <a:ext uri="{9D8B030D-6E8A-4147-A177-3AD203B41FA5}">
                      <a16:colId xmlns:a16="http://schemas.microsoft.com/office/drawing/2014/main" val="1773304688"/>
                    </a:ext>
                  </a:extLst>
                </a:gridCol>
                <a:gridCol w="1059473">
                  <a:extLst>
                    <a:ext uri="{9D8B030D-6E8A-4147-A177-3AD203B41FA5}">
                      <a16:colId xmlns:a16="http://schemas.microsoft.com/office/drawing/2014/main" val="1535596634"/>
                    </a:ext>
                  </a:extLst>
                </a:gridCol>
                <a:gridCol w="633046">
                  <a:extLst>
                    <a:ext uri="{9D8B030D-6E8A-4147-A177-3AD203B41FA5}">
                      <a16:colId xmlns:a16="http://schemas.microsoft.com/office/drawing/2014/main" val="3246226201"/>
                    </a:ext>
                  </a:extLst>
                </a:gridCol>
                <a:gridCol w="1101410">
                  <a:extLst>
                    <a:ext uri="{9D8B030D-6E8A-4147-A177-3AD203B41FA5}">
                      <a16:colId xmlns:a16="http://schemas.microsoft.com/office/drawing/2014/main" val="1744514623"/>
                    </a:ext>
                  </a:extLst>
                </a:gridCol>
                <a:gridCol w="1101410">
                  <a:extLst>
                    <a:ext uri="{9D8B030D-6E8A-4147-A177-3AD203B41FA5}">
                      <a16:colId xmlns:a16="http://schemas.microsoft.com/office/drawing/2014/main" val="527971933"/>
                    </a:ext>
                  </a:extLst>
                </a:gridCol>
                <a:gridCol w="809816">
                  <a:extLst>
                    <a:ext uri="{9D8B030D-6E8A-4147-A177-3AD203B41FA5}">
                      <a16:colId xmlns:a16="http://schemas.microsoft.com/office/drawing/2014/main" val="802683437"/>
                    </a:ext>
                  </a:extLst>
                </a:gridCol>
              </a:tblGrid>
              <a:tr h="245473">
                <a:tc>
                  <a:txBody>
                    <a:bodyPr/>
                    <a:lstStyle/>
                    <a:p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Overall</a:t>
                      </a:r>
                      <a:endParaRPr lang="ja-JP" altLang="en-US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alt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261</a:t>
                      </a:r>
                      <a:r>
                        <a:rPr lang="ja-JP" alt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altLang="en-US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050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mplified frailty assessment</a:t>
                      </a:r>
                      <a:endParaRPr lang="en-US" altLang="ja-JP" sz="105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Standard assessment: J-CHS criteria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8798772"/>
                  </a:ext>
                </a:extLst>
              </a:tr>
              <a:tr h="287344">
                <a:tc>
                  <a:txBody>
                    <a:bodyPr/>
                    <a:lstStyle/>
                    <a:p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63</a:t>
                      </a: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on-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198</a:t>
                      </a: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 value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86</a:t>
                      </a: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on-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1</a:t>
                      </a:r>
                      <a:r>
                        <a:rPr lang="en-US" alt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5</a:t>
                      </a: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 value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3791298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Age (years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3 [70-78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6 [71-7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3 [69-7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19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6 [71-7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2 [69-7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3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9550248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emale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9 (30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0 (32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9 (30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756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1 (48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8 (22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361842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Body mass index (kg/m</a:t>
                      </a:r>
                      <a:r>
                        <a:rPr lang="en-US" sz="1000" kern="100" baseline="30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)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2.6 [20.3-24.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1.5 [19.5-24.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3.0 [20.7-25.4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2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1.4 [19.4-24.4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3.0 [20.8-25.3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4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0638645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SMI (kg/m</a:t>
                      </a:r>
                      <a:r>
                        <a:rPr lang="en-US" sz="1000" kern="100" baseline="30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)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.0 [6.0-7.6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.8 [5.8-7.5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.0 [6.2-7.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13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.4 [5.5-7.3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.2 [6.5-7.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3223452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Sarcopenia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3 (20)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3 (37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0 (15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6 (42)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7 (13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9610835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Serum albumin (g/dl)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.0 [3.7-4.2]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5 [3.4-4.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.0 [3.9-4.3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8 [3.5-4.1]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.1 [3.8-4.3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2689496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Low serum albumin (</a:t>
                      </a:r>
                      <a:r>
                        <a:rPr 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5 g/dl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4 (17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2 (51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2 (7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5 (29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9 (11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6409651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GNRI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2 [96-109]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5 [89-101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4 [98-11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8 [90-104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4 [97-11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3601109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Malnutrition (GNRI &lt; 92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0 (15)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5 (40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5 (8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6 (30)</a:t>
                      </a:r>
                      <a:endParaRPr lang="ja-JP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 (8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&lt;0.0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3194577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EF (%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1 [52-65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0 [51-64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2 [54-66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6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0 [54-65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2 [52-66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83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8211786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P (</a:t>
                      </a:r>
                      <a:r>
                        <a:rPr kumimoji="1" lang="en-US" altLang="ja-JP" sz="105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59 [63-272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93 [102-315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34 [61-259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99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01 [89-327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25 [48-216]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09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0890431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yslipidemia</a:t>
                      </a:r>
                      <a:endParaRPr kumimoji="1" lang="ja-JP" altLang="en-US" sz="10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15 (44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0 (48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85 (43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561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9 (45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6 (43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792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7361983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iabetes mellitus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7 (26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7 (27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0 (25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869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6 (30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2 (23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291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4574325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ypertension</a:t>
                      </a:r>
                      <a:endParaRPr kumimoji="1" lang="ja-JP" altLang="en-US" sz="10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05 (79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2 (83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53 (77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81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9 (80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36 (78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749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0135831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ronic Kidney Disease</a:t>
                      </a:r>
                      <a:endParaRPr kumimoji="1" lang="ja-JP" altLang="en-US" sz="10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9 (30)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5 (40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4 (27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83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6 (30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3 (30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000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318704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ry of cancer</a:t>
                      </a:r>
                      <a:endParaRPr lang="ja-JP" sz="10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5 (13)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 (14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6 (13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816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 (16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1 (12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342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7363143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istory of CVD</a:t>
                      </a:r>
                      <a:endParaRPr kumimoji="1" lang="ja-JP" altLang="en-US" sz="10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1 (35)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9 (46)</a:t>
                      </a:r>
                      <a:endParaRPr lang="ja-JP" alt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2 (31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48</a:t>
                      </a:r>
                      <a:endParaRPr lang="ja-JP" alt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0 (35)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1 (35)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.00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6389289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istory of respiratory disease</a:t>
                      </a:r>
                      <a:endParaRPr kumimoji="1" lang="ja-JP" altLang="en-US" sz="10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0 (8)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 (11)</a:t>
                      </a:r>
                      <a:endParaRPr lang="ja-JP" alt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3 (7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239</a:t>
                      </a:r>
                      <a:endParaRPr lang="ja-JP" alt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8 (9)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2 (7)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87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4080972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EuroSCORE </a:t>
                      </a:r>
                      <a:r>
                        <a:rPr 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Ⅱ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(%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.7 [1.7-4.2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2 [2.0-4.7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.5 [1.7-4.0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83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1 [2.0-4.7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.4 [1.6-4.0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50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83926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JapanSCORE; mortality (%)</a:t>
                      </a:r>
                      <a:endParaRPr lang="ja-JP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3 [1.8-4.8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8 [2.5-5.9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2 [1.6-4.5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80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8 [2.4-5.5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.2 [1.5-4.3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40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1404305"/>
                  </a:ext>
                </a:extLst>
              </a:tr>
              <a:tr h="260650"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JapanSCORE</a:t>
                      </a: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; morbidity (%)</a:t>
                      </a:r>
                      <a:endParaRPr lang="ja-JP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5.0 [10.8-22.7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8.2 [13.3-23.0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.3 [10.4-22.7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20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7.7 [12.9-24.3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.3 [10.3-21.6]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21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9616981"/>
                  </a:ext>
                </a:extLst>
              </a:tr>
            </a:tbl>
          </a:graphicData>
        </a:graphic>
      </p:graphicFrame>
      <p:sp>
        <p:nvSpPr>
          <p:cNvPr id="7" name="タイトル 3">
            <a:extLst>
              <a:ext uri="{FF2B5EF4-FFF2-40B4-BE49-F238E27FC236}">
                <a16:creationId xmlns:a16="http://schemas.microsoft.com/office/drawing/2014/main" id="{62D7001A-90F9-1804-2D0C-543C93771C11}"/>
              </a:ext>
            </a:extLst>
          </p:cNvPr>
          <p:cNvSpPr txBox="1">
            <a:spLocks/>
          </p:cNvSpPr>
          <p:nvPr/>
        </p:nvSpPr>
        <p:spPr>
          <a:xfrm>
            <a:off x="43957" y="-115623"/>
            <a:ext cx="9044609" cy="6056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 sz="2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Table 2 Baseline characteristics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683B5E1-739B-6DFF-CBDF-CE0674057024}"/>
              </a:ext>
            </a:extLst>
          </p:cNvPr>
          <p:cNvSpPr txBox="1"/>
          <p:nvPr/>
        </p:nvSpPr>
        <p:spPr>
          <a:xfrm>
            <a:off x="78204" y="6377607"/>
            <a:ext cx="898835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ta are presented as the median [interquartile range] or n (%).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J-CHS</a:t>
            </a:r>
            <a:r>
              <a:rPr lang="en-US" altLang="ja-JP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Japanese version of the Cardiovascular Health Study    SMI</a:t>
            </a:r>
            <a:r>
              <a:rPr lang="en-US" altLang="ja-JP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keletal muscle mass index    GNRI</a:t>
            </a:r>
            <a:r>
              <a:rPr lang="en-US" altLang="ja-JP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eriatric nutritional risk index    LVEF</a:t>
            </a:r>
            <a:r>
              <a:rPr lang="en-US" altLang="ja-JP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eft ventricle ejection frac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VD</a:t>
            </a:r>
            <a:r>
              <a:rPr lang="en-US" altLang="ja-JP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erebrovascular disease      EuroSCORE</a:t>
            </a:r>
            <a:r>
              <a:rPr lang="en-US" altLang="ja-JP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9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he European System for Cardiac Operative Risk Evaluation </a:t>
            </a:r>
          </a:p>
        </p:txBody>
      </p:sp>
    </p:spTree>
    <p:extLst>
      <p:ext uri="{BB962C8B-B14F-4D97-AF65-F5344CB8AC3E}">
        <p14:creationId xmlns:p14="http://schemas.microsoft.com/office/powerpoint/2010/main" val="31178931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AC0256-6F63-FFF0-E8A0-8EF209362FA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928002C7-F42A-D4DB-EDBD-4759BB801F3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27793642"/>
              </p:ext>
            </p:extLst>
          </p:nvPr>
        </p:nvGraphicFramePr>
        <p:xfrm>
          <a:off x="171212" y="992392"/>
          <a:ext cx="8790098" cy="5020387"/>
        </p:xfrm>
        <a:graphic>
          <a:graphicData uri="http://schemas.openxmlformats.org/drawingml/2006/table">
            <a:tbl>
              <a:tblPr firstRow="1" firstCol="1" bandRow="1"/>
              <a:tblGrid>
                <a:gridCol w="1724208">
                  <a:extLst>
                    <a:ext uri="{9D8B030D-6E8A-4147-A177-3AD203B41FA5}">
                      <a16:colId xmlns:a16="http://schemas.microsoft.com/office/drawing/2014/main" val="1019398454"/>
                    </a:ext>
                  </a:extLst>
                </a:gridCol>
                <a:gridCol w="1202782">
                  <a:extLst>
                    <a:ext uri="{9D8B030D-6E8A-4147-A177-3AD203B41FA5}">
                      <a16:colId xmlns:a16="http://schemas.microsoft.com/office/drawing/2014/main" val="683041976"/>
                    </a:ext>
                  </a:extLst>
                </a:gridCol>
                <a:gridCol w="1197518">
                  <a:extLst>
                    <a:ext uri="{9D8B030D-6E8A-4147-A177-3AD203B41FA5}">
                      <a16:colId xmlns:a16="http://schemas.microsoft.com/office/drawing/2014/main" val="1773304688"/>
                    </a:ext>
                  </a:extLst>
                </a:gridCol>
                <a:gridCol w="1019908">
                  <a:extLst>
                    <a:ext uri="{9D8B030D-6E8A-4147-A177-3AD203B41FA5}">
                      <a16:colId xmlns:a16="http://schemas.microsoft.com/office/drawing/2014/main" val="1535596634"/>
                    </a:ext>
                  </a:extLst>
                </a:gridCol>
                <a:gridCol w="633046">
                  <a:extLst>
                    <a:ext uri="{9D8B030D-6E8A-4147-A177-3AD203B41FA5}">
                      <a16:colId xmlns:a16="http://schemas.microsoft.com/office/drawing/2014/main" val="3246226201"/>
                    </a:ext>
                  </a:extLst>
                </a:gridCol>
                <a:gridCol w="1204076">
                  <a:extLst>
                    <a:ext uri="{9D8B030D-6E8A-4147-A177-3AD203B41FA5}">
                      <a16:colId xmlns:a16="http://schemas.microsoft.com/office/drawing/2014/main" val="1744514623"/>
                    </a:ext>
                  </a:extLst>
                </a:gridCol>
                <a:gridCol w="998744">
                  <a:extLst>
                    <a:ext uri="{9D8B030D-6E8A-4147-A177-3AD203B41FA5}">
                      <a16:colId xmlns:a16="http://schemas.microsoft.com/office/drawing/2014/main" val="527971933"/>
                    </a:ext>
                  </a:extLst>
                </a:gridCol>
                <a:gridCol w="809816">
                  <a:extLst>
                    <a:ext uri="{9D8B030D-6E8A-4147-A177-3AD203B41FA5}">
                      <a16:colId xmlns:a16="http://schemas.microsoft.com/office/drawing/2014/main" val="802683437"/>
                    </a:ext>
                  </a:extLst>
                </a:gridCol>
              </a:tblGrid>
              <a:tr h="264907">
                <a:tc>
                  <a:txBody>
                    <a:bodyPr/>
                    <a:lstStyle/>
                    <a:p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Overall</a:t>
                      </a:r>
                      <a:endParaRPr lang="ja-JP" altLang="en-US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alt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261</a:t>
                      </a:r>
                      <a:r>
                        <a:rPr lang="ja-JP" alt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altLang="en-US" sz="11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050" dirty="0">
                          <a:solidFill>
                            <a:prstClr val="black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mplified frailty assessment</a:t>
                      </a:r>
                      <a:endParaRPr lang="en-US" altLang="ja-JP" sz="105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Standard assessment: J-CHS criteria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8798772"/>
                  </a:ext>
                </a:extLst>
              </a:tr>
              <a:tr h="385723">
                <a:tc>
                  <a:txBody>
                    <a:bodyPr/>
                    <a:lstStyle/>
                    <a:p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dirty="0"/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63</a:t>
                      </a: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on-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198</a:t>
                      </a: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 value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86</a:t>
                      </a: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on-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railty group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n=1</a:t>
                      </a:r>
                      <a:r>
                        <a:rPr lang="en-US" alt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75</a:t>
                      </a:r>
                      <a:r>
                        <a:rPr lang="ja-JP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）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p value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3791298"/>
                  </a:ext>
                </a:extLst>
              </a:tr>
              <a:tr h="71511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ration category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ABG:43     Valve:106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Aorta:105  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Others:7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ABG:9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Valve:33 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 Aorta:19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 Others:2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ABG:34  Valve:73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Aorta:86   Others:5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33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ABG:11 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Valve:47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Aorta:24   </a:t>
                      </a:r>
                      <a:r>
                        <a:rPr lang="ja-JP" alt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　  </a:t>
                      </a:r>
                      <a:endParaRPr lang="en-US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 Others:4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ABG:32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Valve:59</a:t>
                      </a:r>
                    </a:p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Aorta:81   Others:3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30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9550248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bined procedure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1 (23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6 (25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5 (23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733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4 (28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7 (21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276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0638645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ration</a:t>
                      </a:r>
                      <a:r>
                        <a:rPr kumimoji="1" lang="ja-JP" alt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(min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79 [245-326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69 [240-32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81 [250-32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35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63 [233-322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84 [251-32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8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3223452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B time</a:t>
                      </a:r>
                      <a:r>
                        <a:rPr kumimoji="1" lang="ja-JP" alt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in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7 [125-16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6 [126-165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7 [125-172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86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3 [123-171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50 [127-16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0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9610835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mp</a:t>
                      </a:r>
                      <a:r>
                        <a:rPr kumimoji="1" lang="ja-JP" altLang="en-US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</a:t>
                      </a:r>
                      <a:r>
                        <a:rPr kumimoji="1" lang="ja-JP" alt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kumimoji="1" lang="ja-JP" altLang="en-US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in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3 [74-118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9 [83-113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2 [72-11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293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8 [83-11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2 [71-118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7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2689496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</a:t>
                      </a:r>
                      <a:r>
                        <a:rPr kumimoji="1" lang="ja-JP" alt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ss volume (ml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00 [190-48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91 [190-46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10 [190-48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788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20 [210-485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00 [180-46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04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6409651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C transfusion (unit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 [2-6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 [2-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 [2-6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98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 [2-8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 [2-6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20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3601109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FP transfusion (unit)</a:t>
                      </a:r>
                      <a:r>
                        <a:rPr kumimoji="1" lang="ja-JP" alt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 [0-1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 [0-10]</a:t>
                      </a:r>
                      <a:endParaRPr kumimoji="1" lang="ja-JP" altLang="ja-JP" sz="10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 [0-10]</a:t>
                      </a:r>
                      <a:endParaRPr kumimoji="1" lang="ja-JP" altLang="ja-JP" sz="10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90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 [0-10]</a:t>
                      </a:r>
                      <a:endParaRPr kumimoji="1" lang="ja-JP" altLang="ja-JP" sz="10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6 [0-10]</a:t>
                      </a:r>
                      <a:endParaRPr kumimoji="1" lang="ja-JP" altLang="ja-JP" sz="10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64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3194577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 transfusion (unit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 [0-10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 [0-10]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 [0-10]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718</a:t>
                      </a: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 [0-10]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 [0-10]</a:t>
                      </a:r>
                      <a:endParaRPr lang="ja-JP" alt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568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5535830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ubation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(hour)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 [5-1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5 [6-18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 [4-1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2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5 [6-18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4 [4-17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20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7361983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 stay (day)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 [2-3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 [2-3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 [2-4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44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 [2-4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 [2-3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509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4574325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operative</a:t>
                      </a:r>
                      <a:r>
                        <a:rPr kumimoji="1" lang="ja-JP" altLang="en-US" sz="10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84 (32)</a:t>
                      </a:r>
                      <a:endParaRPr lang="ja-JP" sz="10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6 (41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8 (29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089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0 (35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54 (31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573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318704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operative</a:t>
                      </a:r>
                      <a:r>
                        <a:rPr kumimoji="1" lang="ja-JP" altLang="en-US" sz="10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VD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0 (8)</a:t>
                      </a:r>
                      <a:endParaRPr lang="ja-JP" sz="10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 (5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7 (9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2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 (11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1 (6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321</a:t>
                      </a:r>
                      <a:endParaRPr lang="ja-JP" sz="10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7363143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ound complication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3 (5)</a:t>
                      </a:r>
                      <a:endParaRPr lang="ja-JP" sz="10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4 (6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9 (5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521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3 (4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10 (6)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555</a:t>
                      </a:r>
                      <a:endParaRPr lang="ja-JP" sz="10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0617037"/>
                  </a:ext>
                </a:extLst>
              </a:tr>
              <a:tr h="26104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mission days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1 [16-26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2 [17-29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1 [16-26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138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2 [16-28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sz="10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21 [16-26]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42170" marR="4217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buNone/>
                      </a:pPr>
                      <a:r>
                        <a:rPr lang="en-US" altLang="ja-JP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0.461</a:t>
                      </a:r>
                      <a:endParaRPr lang="ja-JP" sz="10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6389289"/>
                  </a:ext>
                </a:extLst>
              </a:tr>
            </a:tbl>
          </a:graphicData>
        </a:graphic>
      </p:graphicFrame>
      <p:sp>
        <p:nvSpPr>
          <p:cNvPr id="7" name="タイトル 3">
            <a:extLst>
              <a:ext uri="{FF2B5EF4-FFF2-40B4-BE49-F238E27FC236}">
                <a16:creationId xmlns:a16="http://schemas.microsoft.com/office/drawing/2014/main" id="{DABE5173-7BA7-A574-D9C3-4999976AF647}"/>
              </a:ext>
            </a:extLst>
          </p:cNvPr>
          <p:cNvSpPr txBox="1">
            <a:spLocks/>
          </p:cNvSpPr>
          <p:nvPr/>
        </p:nvSpPr>
        <p:spPr>
          <a:xfrm>
            <a:off x="43956" y="237769"/>
            <a:ext cx="9044609" cy="6056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 sz="2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Table 3 Perioperative Data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5858132-A6C2-68CE-7199-33C043CC0C41}"/>
              </a:ext>
            </a:extLst>
          </p:cNvPr>
          <p:cNvSpPr txBox="1"/>
          <p:nvPr/>
        </p:nvSpPr>
        <p:spPr>
          <a:xfrm>
            <a:off x="171212" y="6064949"/>
            <a:ext cx="7697941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ta are presented as the median [interquartile range] or n (%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BG</a:t>
            </a:r>
            <a:r>
              <a:rPr lang="en-US" altLang="ja-JP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ronary artery bypass grafting</a:t>
            </a:r>
            <a:r>
              <a:rPr kumimoji="1" lang="ja-JP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　　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PB</a:t>
            </a:r>
            <a:r>
              <a:rPr lang="en-US" altLang="ja-JP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rdio-pulmonary bypass    RBC</a:t>
            </a:r>
            <a:r>
              <a:rPr lang="en-US" altLang="ja-JP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red blood cell      FFP</a:t>
            </a:r>
            <a:r>
              <a:rPr lang="en-US" altLang="ja-JP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resh frozen plasma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C</a:t>
            </a:r>
            <a:r>
              <a:rPr lang="en-US" altLang="ja-JP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latelet concentrate    ICU</a:t>
            </a:r>
            <a:r>
              <a:rPr lang="en-US" altLang="ja-JP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ntensive care unit     AF</a:t>
            </a:r>
            <a:r>
              <a:rPr lang="en-US" altLang="ja-JP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trial fibrillation     CVD</a:t>
            </a:r>
            <a:r>
              <a:rPr lang="en-US" altLang="ja-JP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05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erebrovascular disease</a:t>
            </a:r>
          </a:p>
        </p:txBody>
      </p:sp>
    </p:spTree>
    <p:extLst>
      <p:ext uri="{BB962C8B-B14F-4D97-AF65-F5344CB8AC3E}">
        <p14:creationId xmlns:p14="http://schemas.microsoft.com/office/powerpoint/2010/main" val="39533378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4CF9657-0783-7A2E-C286-0B2217FA14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四角形: 角を丸くする 1">
            <a:extLst>
              <a:ext uri="{FF2B5EF4-FFF2-40B4-BE49-F238E27FC236}">
                <a16:creationId xmlns:a16="http://schemas.microsoft.com/office/drawing/2014/main" id="{DC1939B8-D8AB-72EA-7903-CE1280B3C04A}"/>
              </a:ext>
            </a:extLst>
          </p:cNvPr>
          <p:cNvSpPr/>
          <p:nvPr/>
        </p:nvSpPr>
        <p:spPr>
          <a:xfrm>
            <a:off x="322729" y="591663"/>
            <a:ext cx="4077148" cy="5368073"/>
          </a:xfrm>
          <a:prstGeom prst="roundRect">
            <a:avLst>
              <a:gd name="adj" fmla="val 3738"/>
            </a:avLst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四角形: 角を丸くする 2">
            <a:extLst>
              <a:ext uri="{FF2B5EF4-FFF2-40B4-BE49-F238E27FC236}">
                <a16:creationId xmlns:a16="http://schemas.microsoft.com/office/drawing/2014/main" id="{711BEA72-24C9-AEEE-BEB3-7D65436FED7B}"/>
              </a:ext>
            </a:extLst>
          </p:cNvPr>
          <p:cNvSpPr/>
          <p:nvPr/>
        </p:nvSpPr>
        <p:spPr>
          <a:xfrm>
            <a:off x="4744123" y="591663"/>
            <a:ext cx="4077148" cy="5368074"/>
          </a:xfrm>
          <a:prstGeom prst="roundRect">
            <a:avLst>
              <a:gd name="adj" fmla="val 3738"/>
            </a:avLst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四角形: 角を丸くする 3">
            <a:extLst>
              <a:ext uri="{FF2B5EF4-FFF2-40B4-BE49-F238E27FC236}">
                <a16:creationId xmlns:a16="http://schemas.microsoft.com/office/drawing/2014/main" id="{13ADD121-9F0B-6BEC-EF70-0B883F34AF31}"/>
              </a:ext>
            </a:extLst>
          </p:cNvPr>
          <p:cNvSpPr/>
          <p:nvPr/>
        </p:nvSpPr>
        <p:spPr>
          <a:xfrm>
            <a:off x="753933" y="210659"/>
            <a:ext cx="3279290" cy="800550"/>
          </a:xfrm>
          <a:prstGeom prst="roundRect">
            <a:avLst>
              <a:gd name="adj" fmla="val 3738"/>
            </a:avLst>
          </a:prstGeom>
          <a:solidFill>
            <a:schemeClr val="bg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ndard frailty assessment</a:t>
            </a:r>
            <a:endParaRPr kumimoji="1" lang="en-US" altLang="ja-JP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J-CHS criteria: 5-item)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四角形: 角を丸くする 4">
            <a:extLst>
              <a:ext uri="{FF2B5EF4-FFF2-40B4-BE49-F238E27FC236}">
                <a16:creationId xmlns:a16="http://schemas.microsoft.com/office/drawing/2014/main" id="{6BBB574C-E27B-DE0B-AA00-8FCBFECB4C1B}"/>
              </a:ext>
            </a:extLst>
          </p:cNvPr>
          <p:cNvSpPr/>
          <p:nvPr/>
        </p:nvSpPr>
        <p:spPr>
          <a:xfrm>
            <a:off x="5045340" y="212455"/>
            <a:ext cx="3506098" cy="798754"/>
          </a:xfrm>
          <a:prstGeom prst="roundRect">
            <a:avLst>
              <a:gd name="adj" fmla="val 3738"/>
            </a:avLst>
          </a:prstGeom>
          <a:solidFill>
            <a:schemeClr val="bg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mplified frailty assessment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new 3-item model)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32ADCCD-66D7-0619-3D39-A3B3F5367809}"/>
              </a:ext>
            </a:extLst>
          </p:cNvPr>
          <p:cNvSpPr txBox="1"/>
          <p:nvPr/>
        </p:nvSpPr>
        <p:spPr>
          <a:xfrm>
            <a:off x="812667" y="5382532"/>
            <a:ext cx="1755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b="1" dirty="0"/>
              <a:t>≥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 criteria met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楕円 22">
            <a:extLst>
              <a:ext uri="{FF2B5EF4-FFF2-40B4-BE49-F238E27FC236}">
                <a16:creationId xmlns:a16="http://schemas.microsoft.com/office/drawing/2014/main" id="{1A96B609-E327-409F-5EE8-69B4C74FDD73}"/>
              </a:ext>
            </a:extLst>
          </p:cNvPr>
          <p:cNvSpPr/>
          <p:nvPr/>
        </p:nvSpPr>
        <p:spPr>
          <a:xfrm>
            <a:off x="1688950" y="1281163"/>
            <a:ext cx="1366222" cy="1407911"/>
          </a:xfrm>
          <a:prstGeom prst="ellipse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ight loss</a:t>
            </a:r>
          </a:p>
          <a:p>
            <a:pPr algn="ctr"/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≥2 kg in 6 months</a:t>
            </a:r>
            <a:endParaRPr kumimoji="1" lang="ja-JP" altLang="en-US" sz="1200" dirty="0"/>
          </a:p>
        </p:txBody>
      </p:sp>
      <p:sp>
        <p:nvSpPr>
          <p:cNvPr id="24" name="楕円 23">
            <a:extLst>
              <a:ext uri="{FF2B5EF4-FFF2-40B4-BE49-F238E27FC236}">
                <a16:creationId xmlns:a16="http://schemas.microsoft.com/office/drawing/2014/main" id="{D6E0FD86-C982-5B4D-FCE2-1B023F73EB96}"/>
              </a:ext>
            </a:extLst>
          </p:cNvPr>
          <p:cNvSpPr/>
          <p:nvPr/>
        </p:nvSpPr>
        <p:spPr>
          <a:xfrm>
            <a:off x="519947" y="2237464"/>
            <a:ext cx="1418934" cy="1407911"/>
          </a:xfrm>
          <a:prstGeom prst="ellipse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 dirty="0"/>
          </a:p>
        </p:txBody>
      </p:sp>
      <p:sp>
        <p:nvSpPr>
          <p:cNvPr id="25" name="楕円 24">
            <a:extLst>
              <a:ext uri="{FF2B5EF4-FFF2-40B4-BE49-F238E27FC236}">
                <a16:creationId xmlns:a16="http://schemas.microsoft.com/office/drawing/2014/main" id="{A3573805-BB22-6CE6-9B5E-299AEC2A575D}"/>
              </a:ext>
            </a:extLst>
          </p:cNvPr>
          <p:cNvSpPr/>
          <p:nvPr/>
        </p:nvSpPr>
        <p:spPr>
          <a:xfrm>
            <a:off x="2829441" y="2198245"/>
            <a:ext cx="1418934" cy="1407911"/>
          </a:xfrm>
          <a:prstGeom prst="ellipse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 physical activity</a:t>
            </a:r>
            <a:r>
              <a:rPr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400" dirty="0"/>
          </a:p>
        </p:txBody>
      </p:sp>
      <p:sp>
        <p:nvSpPr>
          <p:cNvPr id="26" name="楕円 25">
            <a:extLst>
              <a:ext uri="{FF2B5EF4-FFF2-40B4-BE49-F238E27FC236}">
                <a16:creationId xmlns:a16="http://schemas.microsoft.com/office/drawing/2014/main" id="{172DC368-36C2-778E-2B26-3DD211625D5F}"/>
              </a:ext>
            </a:extLst>
          </p:cNvPr>
          <p:cNvSpPr/>
          <p:nvPr/>
        </p:nvSpPr>
        <p:spPr>
          <a:xfrm>
            <a:off x="974641" y="3634618"/>
            <a:ext cx="1418934" cy="1407911"/>
          </a:xfrm>
          <a:prstGeom prst="ellipse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owness</a:t>
            </a:r>
          </a:p>
          <a:p>
            <a:pPr algn="ctr"/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it speed &lt;1.0 m/s </a:t>
            </a:r>
            <a:endParaRPr kumimoji="1" lang="ja-JP" altLang="en-US" sz="1200" dirty="0"/>
          </a:p>
        </p:txBody>
      </p:sp>
      <p:sp>
        <p:nvSpPr>
          <p:cNvPr id="27" name="楕円 26">
            <a:extLst>
              <a:ext uri="{FF2B5EF4-FFF2-40B4-BE49-F238E27FC236}">
                <a16:creationId xmlns:a16="http://schemas.microsoft.com/office/drawing/2014/main" id="{92829DEF-1DAC-BEFA-D656-B52D5B7094FC}"/>
              </a:ext>
            </a:extLst>
          </p:cNvPr>
          <p:cNvSpPr/>
          <p:nvPr/>
        </p:nvSpPr>
        <p:spPr>
          <a:xfrm>
            <a:off x="2482510" y="3647164"/>
            <a:ext cx="1418934" cy="1407911"/>
          </a:xfrm>
          <a:prstGeom prst="ellipse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sz="13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ip strength &lt;28 kg (M)  &lt;18 kg (W) </a:t>
            </a:r>
            <a:endParaRPr kumimoji="1" lang="ja-JP" altLang="en-US" sz="11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38BAEE5-C1BB-E049-D15B-445EC8082553}"/>
              </a:ext>
            </a:extLst>
          </p:cNvPr>
          <p:cNvSpPr txBox="1"/>
          <p:nvPr/>
        </p:nvSpPr>
        <p:spPr>
          <a:xfrm>
            <a:off x="662982" y="2763993"/>
            <a:ext cx="11480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xhaustion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651CB97-8ED9-7528-41D9-F04ED57007A0}"/>
              </a:ext>
            </a:extLst>
          </p:cNvPr>
          <p:cNvSpPr txBox="1"/>
          <p:nvPr/>
        </p:nvSpPr>
        <p:spPr>
          <a:xfrm>
            <a:off x="2660973" y="3905740"/>
            <a:ext cx="10566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Weakness</a:t>
            </a:r>
          </a:p>
        </p:txBody>
      </p:sp>
      <p:sp>
        <p:nvSpPr>
          <p:cNvPr id="30" name="矢印: 右 29">
            <a:extLst>
              <a:ext uri="{FF2B5EF4-FFF2-40B4-BE49-F238E27FC236}">
                <a16:creationId xmlns:a16="http://schemas.microsoft.com/office/drawing/2014/main" id="{094B2C1C-1BAC-5D6E-3F9A-A7B3D1D89BAD}"/>
              </a:ext>
            </a:extLst>
          </p:cNvPr>
          <p:cNvSpPr/>
          <p:nvPr/>
        </p:nvSpPr>
        <p:spPr>
          <a:xfrm>
            <a:off x="2544189" y="5450771"/>
            <a:ext cx="411777" cy="279577"/>
          </a:xfrm>
          <a:prstGeom prst="rightArrow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CD49D15-E9B5-7E1B-2E8B-0A1D78A602A0}"/>
              </a:ext>
            </a:extLst>
          </p:cNvPr>
          <p:cNvSpPr txBox="1"/>
          <p:nvPr/>
        </p:nvSpPr>
        <p:spPr>
          <a:xfrm>
            <a:off x="3023957" y="5405893"/>
            <a:ext cx="102303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railty 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四角形: 角を丸くする 35">
            <a:extLst>
              <a:ext uri="{FF2B5EF4-FFF2-40B4-BE49-F238E27FC236}">
                <a16:creationId xmlns:a16="http://schemas.microsoft.com/office/drawing/2014/main" id="{0850DD08-602C-C619-A009-64AC3DF90672}"/>
              </a:ext>
            </a:extLst>
          </p:cNvPr>
          <p:cNvSpPr/>
          <p:nvPr/>
        </p:nvSpPr>
        <p:spPr>
          <a:xfrm>
            <a:off x="5106664" y="1479820"/>
            <a:ext cx="3369467" cy="800550"/>
          </a:xfrm>
          <a:prstGeom prst="roundRect">
            <a:avLst>
              <a:gd name="adj" fmla="val 3738"/>
            </a:avLst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lowness*</a:t>
            </a:r>
          </a:p>
          <a:p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gait speed &lt;1.0 m/s </a:t>
            </a:r>
          </a:p>
        </p:txBody>
      </p:sp>
      <p:sp>
        <p:nvSpPr>
          <p:cNvPr id="37" name="四角形: 角を丸くする 36">
            <a:extLst>
              <a:ext uri="{FF2B5EF4-FFF2-40B4-BE49-F238E27FC236}">
                <a16:creationId xmlns:a16="http://schemas.microsoft.com/office/drawing/2014/main" id="{653AEC2F-26F8-C23C-495D-CA2FE0DEFC2F}"/>
              </a:ext>
            </a:extLst>
          </p:cNvPr>
          <p:cNvSpPr/>
          <p:nvPr/>
        </p:nvSpPr>
        <p:spPr>
          <a:xfrm>
            <a:off x="5106664" y="2583235"/>
            <a:ext cx="3369467" cy="800550"/>
          </a:xfrm>
          <a:prstGeom prst="roundRect">
            <a:avLst>
              <a:gd name="adj" fmla="val 3738"/>
            </a:avLst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ypoalbuminemia*</a:t>
            </a:r>
          </a:p>
          <a:p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albumin ≤3.5 g/dL</a:t>
            </a:r>
          </a:p>
        </p:txBody>
      </p:sp>
      <p:sp>
        <p:nvSpPr>
          <p:cNvPr id="38" name="四角形: 角を丸くする 37">
            <a:extLst>
              <a:ext uri="{FF2B5EF4-FFF2-40B4-BE49-F238E27FC236}">
                <a16:creationId xmlns:a16="http://schemas.microsoft.com/office/drawing/2014/main" id="{B1E8847B-186D-C9DB-F596-14B01634499E}"/>
              </a:ext>
            </a:extLst>
          </p:cNvPr>
          <p:cNvSpPr/>
          <p:nvPr/>
        </p:nvSpPr>
        <p:spPr>
          <a:xfrm>
            <a:off x="5106664" y="3688407"/>
            <a:ext cx="3369467" cy="894351"/>
          </a:xfrm>
          <a:prstGeom prst="roundRect">
            <a:avLst>
              <a:gd name="adj" fmla="val 3738"/>
            </a:avLst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akness</a:t>
            </a:r>
          </a:p>
          <a:p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grip strength &lt;28 kg (M)</a:t>
            </a:r>
          </a:p>
          <a:p>
            <a:r>
              <a:rPr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    </a:t>
            </a:r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18 kg (W) 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02D5012-6CF4-85F7-09D6-C2F671A17224}"/>
              </a:ext>
            </a:extLst>
          </p:cNvPr>
          <p:cNvSpPr txBox="1"/>
          <p:nvPr/>
        </p:nvSpPr>
        <p:spPr>
          <a:xfrm>
            <a:off x="5149693" y="5382532"/>
            <a:ext cx="1755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≥2 criteria met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矢印: 右 39">
            <a:extLst>
              <a:ext uri="{FF2B5EF4-FFF2-40B4-BE49-F238E27FC236}">
                <a16:creationId xmlns:a16="http://schemas.microsoft.com/office/drawing/2014/main" id="{58AB6C9C-C03B-7D8C-78A1-0D95787B4166}"/>
              </a:ext>
            </a:extLst>
          </p:cNvPr>
          <p:cNvSpPr/>
          <p:nvPr/>
        </p:nvSpPr>
        <p:spPr>
          <a:xfrm>
            <a:off x="6881215" y="5450771"/>
            <a:ext cx="411777" cy="279577"/>
          </a:xfrm>
          <a:prstGeom prst="rightArrow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4FD5F88-8A7C-9F9D-52A9-5BC608F46A5A}"/>
              </a:ext>
            </a:extLst>
          </p:cNvPr>
          <p:cNvSpPr txBox="1"/>
          <p:nvPr/>
        </p:nvSpPr>
        <p:spPr>
          <a:xfrm>
            <a:off x="7360983" y="5405893"/>
            <a:ext cx="102303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railty 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グラフィックス 43" descr="歩く 単色塗りつぶし">
            <a:extLst>
              <a:ext uri="{FF2B5EF4-FFF2-40B4-BE49-F238E27FC236}">
                <a16:creationId xmlns:a16="http://schemas.microsoft.com/office/drawing/2014/main" id="{F7636D8B-A457-385F-7B64-DEC454A6A6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31833" y="4317963"/>
            <a:ext cx="724566" cy="724566"/>
          </a:xfrm>
          <a:prstGeom prst="rect">
            <a:avLst/>
          </a:prstGeom>
        </p:spPr>
      </p:pic>
      <p:pic>
        <p:nvPicPr>
          <p:cNvPr id="45" name="グラフィックス 44" descr="歩く 単色塗りつぶし">
            <a:extLst>
              <a:ext uri="{FF2B5EF4-FFF2-40B4-BE49-F238E27FC236}">
                <a16:creationId xmlns:a16="http://schemas.microsoft.com/office/drawing/2014/main" id="{E22C2CA0-1551-F50F-2570-7B5053D694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542492" y="1538846"/>
            <a:ext cx="724566" cy="724566"/>
          </a:xfrm>
          <a:prstGeom prst="rect">
            <a:avLst/>
          </a:prstGeom>
        </p:spPr>
      </p:pic>
      <p:pic>
        <p:nvPicPr>
          <p:cNvPr id="47" name="グラフィックス 46" descr="注射針 単色塗りつぶし">
            <a:extLst>
              <a:ext uri="{FF2B5EF4-FFF2-40B4-BE49-F238E27FC236}">
                <a16:creationId xmlns:a16="http://schemas.microsoft.com/office/drawing/2014/main" id="{E165EFBC-C563-CFF7-AA32-997A3B6A90E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530351" y="2631132"/>
            <a:ext cx="734271" cy="734271"/>
          </a:xfrm>
          <a:prstGeom prst="rect">
            <a:avLst/>
          </a:prstGeom>
        </p:spPr>
      </p:pic>
      <p:pic>
        <p:nvPicPr>
          <p:cNvPr id="1026" name="Picture 2" descr="握力計」の写真素材 | 40件の無料イラスト画像 | Adobe Stock">
            <a:extLst>
              <a:ext uri="{FF2B5EF4-FFF2-40B4-BE49-F238E27FC236}">
                <a16:creationId xmlns:a16="http://schemas.microsoft.com/office/drawing/2014/main" id="{511562D4-7E34-992A-0A23-0E27F4423D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6424" y="4273676"/>
            <a:ext cx="789266" cy="7892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2" descr="握力計」の写真素材 | 40件の無料イラスト画像 | Adobe Stock">
            <a:extLst>
              <a:ext uri="{FF2B5EF4-FFF2-40B4-BE49-F238E27FC236}">
                <a16:creationId xmlns:a16="http://schemas.microsoft.com/office/drawing/2014/main" id="{68108B2A-A33D-C12C-E997-85DA3958EE4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1658" y="3752234"/>
            <a:ext cx="789266" cy="7892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タイトル 3">
            <a:extLst>
              <a:ext uri="{FF2B5EF4-FFF2-40B4-BE49-F238E27FC236}">
                <a16:creationId xmlns:a16="http://schemas.microsoft.com/office/drawing/2014/main" id="{3EF3E72C-5FC8-83D6-F742-5636E803AAE8}"/>
              </a:ext>
            </a:extLst>
          </p:cNvPr>
          <p:cNvSpPr txBox="1">
            <a:spLocks/>
          </p:cNvSpPr>
          <p:nvPr/>
        </p:nvSpPr>
        <p:spPr>
          <a:xfrm>
            <a:off x="0" y="6266337"/>
            <a:ext cx="9144000" cy="605631"/>
          </a:xfrm>
          <a:prstGeom prst="rect">
            <a:avLst/>
          </a:prstGeom>
        </p:spPr>
        <p:txBody>
          <a:bodyPr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6858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F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gure</a:t>
            </a:r>
            <a:r>
              <a:rPr lang="ja-JP" altLang="en-US" sz="2000" dirty="0">
                <a:solidFill>
                  <a:prstClr val="black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solidFill>
                  <a:prstClr val="black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Standard and simplified frailty assessment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9280BBA-BBD9-75CC-E486-2E07F71274CF}"/>
              </a:ext>
            </a:extLst>
          </p:cNvPr>
          <p:cNvSpPr txBox="1"/>
          <p:nvPr/>
        </p:nvSpPr>
        <p:spPr>
          <a:xfrm>
            <a:off x="334686" y="5975436"/>
            <a:ext cx="40771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J-CHS</a:t>
            </a:r>
            <a:r>
              <a:rPr lang="en-US" altLang="ja-JP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:</a:t>
            </a:r>
            <a:r>
              <a:rPr lang="ja-JP" altLang="en-US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Japanese version of the Cardiovascular Health Study   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432CB04-44DF-5D3F-8178-DC048D7494A6}"/>
              </a:ext>
            </a:extLst>
          </p:cNvPr>
          <p:cNvSpPr txBox="1"/>
          <p:nvPr/>
        </p:nvSpPr>
        <p:spPr>
          <a:xfrm>
            <a:off x="4759815" y="4689101"/>
            <a:ext cx="407714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＊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tems recommended by the European Society of Cardiology</a:t>
            </a:r>
          </a:p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1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 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statement for the initial assessment of frailty </a:t>
            </a:r>
          </a:p>
        </p:txBody>
      </p:sp>
    </p:spTree>
    <p:extLst>
      <p:ext uri="{BB962C8B-B14F-4D97-AF65-F5344CB8AC3E}">
        <p14:creationId xmlns:p14="http://schemas.microsoft.com/office/powerpoint/2010/main" val="26249356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86A4FB-6853-EB27-4C4F-CA42A185A9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5">
            <a:extLst>
              <a:ext uri="{FF2B5EF4-FFF2-40B4-BE49-F238E27FC236}">
                <a16:creationId xmlns:a16="http://schemas.microsoft.com/office/drawing/2014/main" id="{B73E502C-A5C3-D5F3-8FA1-2E494F0BA3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7746" y="5490549"/>
            <a:ext cx="80791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Specificity</a:t>
            </a:r>
            <a:endParaRPr kumimoji="0" lang="ja-JP" altLang="ja-JP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Rectangle 6">
            <a:extLst>
              <a:ext uri="{FF2B5EF4-FFF2-40B4-BE49-F238E27FC236}">
                <a16:creationId xmlns:a16="http://schemas.microsoft.com/office/drawing/2014/main" id="{645803D4-EF84-9DA7-CA50-076D0B81846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308305" y="2670368"/>
            <a:ext cx="80791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Sensitivity</a:t>
            </a:r>
            <a:endParaRPr kumimoji="0" lang="ja-JP" altLang="ja-JP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Rectangle 7">
            <a:extLst>
              <a:ext uri="{FF2B5EF4-FFF2-40B4-BE49-F238E27FC236}">
                <a16:creationId xmlns:a16="http://schemas.microsoft.com/office/drawing/2014/main" id="{FC3FD6C2-FB5D-CA35-AC68-9B29A575F7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3894" y="481080"/>
            <a:ext cx="4553838" cy="4553842"/>
          </a:xfrm>
          <a:prstGeom prst="rect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Line 8">
            <a:extLst>
              <a:ext uri="{FF2B5EF4-FFF2-40B4-BE49-F238E27FC236}">
                <a16:creationId xmlns:a16="http://schemas.microsoft.com/office/drawing/2014/main" id="{7EAC14CA-EB67-DE5A-5612-598044DD257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68213" y="5034922"/>
            <a:ext cx="421303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" name="Line 9">
            <a:extLst>
              <a:ext uri="{FF2B5EF4-FFF2-40B4-BE49-F238E27FC236}">
                <a16:creationId xmlns:a16="http://schemas.microsoft.com/office/drawing/2014/main" id="{E43B35CE-C367-73CE-CE6E-793FBD465E09}"/>
              </a:ext>
            </a:extLst>
          </p:cNvPr>
          <p:cNvSpPr>
            <a:spLocks noChangeShapeType="1"/>
          </p:cNvSpPr>
          <p:nvPr/>
        </p:nvSpPr>
        <p:spPr bwMode="auto">
          <a:xfrm>
            <a:off x="6881247" y="5034922"/>
            <a:ext cx="0" cy="8226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Line 10">
            <a:extLst>
              <a:ext uri="{FF2B5EF4-FFF2-40B4-BE49-F238E27FC236}">
                <a16:creationId xmlns:a16="http://schemas.microsoft.com/office/drawing/2014/main" id="{24F74A8F-14C4-3DC3-CB1C-B947C4034FB4}"/>
              </a:ext>
            </a:extLst>
          </p:cNvPr>
          <p:cNvSpPr>
            <a:spLocks noChangeShapeType="1"/>
          </p:cNvSpPr>
          <p:nvPr/>
        </p:nvSpPr>
        <p:spPr bwMode="auto">
          <a:xfrm>
            <a:off x="6033156" y="5034922"/>
            <a:ext cx="0" cy="8226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" name="Line 11">
            <a:extLst>
              <a:ext uri="{FF2B5EF4-FFF2-40B4-BE49-F238E27FC236}">
                <a16:creationId xmlns:a16="http://schemas.microsoft.com/office/drawing/2014/main" id="{70270078-6870-EA89-B49B-229D0CD0D6EA}"/>
              </a:ext>
            </a:extLst>
          </p:cNvPr>
          <p:cNvSpPr>
            <a:spLocks noChangeShapeType="1"/>
          </p:cNvSpPr>
          <p:nvPr/>
        </p:nvSpPr>
        <p:spPr bwMode="auto">
          <a:xfrm>
            <a:off x="5194858" y="5034922"/>
            <a:ext cx="0" cy="8226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Line 12">
            <a:extLst>
              <a:ext uri="{FF2B5EF4-FFF2-40B4-BE49-F238E27FC236}">
                <a16:creationId xmlns:a16="http://schemas.microsoft.com/office/drawing/2014/main" id="{D3FAD3FC-3078-2492-45D4-0C7E5BD05A66}"/>
              </a:ext>
            </a:extLst>
          </p:cNvPr>
          <p:cNvSpPr>
            <a:spLocks noChangeShapeType="1"/>
          </p:cNvSpPr>
          <p:nvPr/>
        </p:nvSpPr>
        <p:spPr bwMode="auto">
          <a:xfrm>
            <a:off x="4346767" y="5034922"/>
            <a:ext cx="0" cy="8226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Line 13">
            <a:extLst>
              <a:ext uri="{FF2B5EF4-FFF2-40B4-BE49-F238E27FC236}">
                <a16:creationId xmlns:a16="http://schemas.microsoft.com/office/drawing/2014/main" id="{C0F877E3-71F4-0F31-EA97-C9D2D0FC9F8A}"/>
              </a:ext>
            </a:extLst>
          </p:cNvPr>
          <p:cNvSpPr>
            <a:spLocks noChangeShapeType="1"/>
          </p:cNvSpPr>
          <p:nvPr/>
        </p:nvSpPr>
        <p:spPr bwMode="auto">
          <a:xfrm>
            <a:off x="3508469" y="5034922"/>
            <a:ext cx="0" cy="8226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9" name="Line 14">
            <a:extLst>
              <a:ext uri="{FF2B5EF4-FFF2-40B4-BE49-F238E27FC236}">
                <a16:creationId xmlns:a16="http://schemas.microsoft.com/office/drawing/2014/main" id="{0CB73C71-D1AB-4636-A142-C7B5950B908F}"/>
              </a:ext>
            </a:extLst>
          </p:cNvPr>
          <p:cNvSpPr>
            <a:spLocks noChangeShapeType="1"/>
          </p:cNvSpPr>
          <p:nvPr/>
        </p:nvSpPr>
        <p:spPr bwMode="auto">
          <a:xfrm>
            <a:off x="2668213" y="5034922"/>
            <a:ext cx="0" cy="82263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Rectangle 15">
            <a:extLst>
              <a:ext uri="{FF2B5EF4-FFF2-40B4-BE49-F238E27FC236}">
                <a16:creationId xmlns:a16="http://schemas.microsoft.com/office/drawing/2014/main" id="{295BA67D-DCDE-7345-2FCA-388557C1EE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5232" y="5228828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1.0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1" name="Rectangle 16">
            <a:extLst>
              <a:ext uri="{FF2B5EF4-FFF2-40B4-BE49-F238E27FC236}">
                <a16:creationId xmlns:a16="http://schemas.microsoft.com/office/drawing/2014/main" id="{45140564-5FCB-3F11-132A-B641894721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5488" y="5228828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8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17">
            <a:extLst>
              <a:ext uri="{FF2B5EF4-FFF2-40B4-BE49-F238E27FC236}">
                <a16:creationId xmlns:a16="http://schemas.microsoft.com/office/drawing/2014/main" id="{C4A6F25A-52D7-D4C3-1D00-25DFCC137A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03786" y="5228828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6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18">
            <a:extLst>
              <a:ext uri="{FF2B5EF4-FFF2-40B4-BE49-F238E27FC236}">
                <a16:creationId xmlns:a16="http://schemas.microsoft.com/office/drawing/2014/main" id="{3E0B9971-2C92-3B2E-C7D8-FDAD7A8BC8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1877" y="5228828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4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19">
            <a:extLst>
              <a:ext uri="{FF2B5EF4-FFF2-40B4-BE49-F238E27FC236}">
                <a16:creationId xmlns:a16="http://schemas.microsoft.com/office/drawing/2014/main" id="{DD0E87E2-260B-08BE-36C7-E3829DC17C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0175" y="5228828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2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20">
            <a:extLst>
              <a:ext uri="{FF2B5EF4-FFF2-40B4-BE49-F238E27FC236}">
                <a16:creationId xmlns:a16="http://schemas.microsoft.com/office/drawing/2014/main" id="{882A9AE5-CAA9-995A-7D7A-92FF61FE9E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38267" y="5228828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0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Line 21">
            <a:extLst>
              <a:ext uri="{FF2B5EF4-FFF2-40B4-BE49-F238E27FC236}">
                <a16:creationId xmlns:a16="http://schemas.microsoft.com/office/drawing/2014/main" id="{67A13620-E113-2E8D-1989-765B6248399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93894" y="647565"/>
            <a:ext cx="0" cy="421303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7" name="Line 22">
            <a:extLst>
              <a:ext uri="{FF2B5EF4-FFF2-40B4-BE49-F238E27FC236}">
                <a16:creationId xmlns:a16="http://schemas.microsoft.com/office/drawing/2014/main" id="{60EB03F7-1E2B-1341-7983-090EC01750D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11631" y="4860603"/>
            <a:ext cx="8226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" name="Line 23">
            <a:extLst>
              <a:ext uri="{FF2B5EF4-FFF2-40B4-BE49-F238E27FC236}">
                <a16:creationId xmlns:a16="http://schemas.microsoft.com/office/drawing/2014/main" id="{34A8CF4C-6219-37E6-348E-94AFAB5E9FE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11631" y="4020346"/>
            <a:ext cx="8226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Line 24">
            <a:extLst>
              <a:ext uri="{FF2B5EF4-FFF2-40B4-BE49-F238E27FC236}">
                <a16:creationId xmlns:a16="http://schemas.microsoft.com/office/drawing/2014/main" id="{19F4CAE3-7791-498E-ED98-EF36CFB70D1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11631" y="3182047"/>
            <a:ext cx="8226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0" name="Line 25">
            <a:extLst>
              <a:ext uri="{FF2B5EF4-FFF2-40B4-BE49-F238E27FC236}">
                <a16:creationId xmlns:a16="http://schemas.microsoft.com/office/drawing/2014/main" id="{40AEE5A7-2C24-F772-C765-DC4FDCDCDDB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11631" y="2333955"/>
            <a:ext cx="8226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1" name="Line 26">
            <a:extLst>
              <a:ext uri="{FF2B5EF4-FFF2-40B4-BE49-F238E27FC236}">
                <a16:creationId xmlns:a16="http://schemas.microsoft.com/office/drawing/2014/main" id="{AFD0AD06-A0B4-8931-340E-507B0EA3962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11631" y="1495656"/>
            <a:ext cx="8226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2" name="Line 27">
            <a:extLst>
              <a:ext uri="{FF2B5EF4-FFF2-40B4-BE49-F238E27FC236}">
                <a16:creationId xmlns:a16="http://schemas.microsoft.com/office/drawing/2014/main" id="{4E60D46B-9B7C-9A6C-10F6-D6095F91B43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411631" y="647565"/>
            <a:ext cx="8226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28">
            <a:extLst>
              <a:ext uri="{FF2B5EF4-FFF2-40B4-BE49-F238E27FC236}">
                <a16:creationId xmlns:a16="http://schemas.microsoft.com/office/drawing/2014/main" id="{8454B553-9E22-8AB9-BCA2-D0B1A0FEB9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3613" y="4803803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0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29">
            <a:extLst>
              <a:ext uri="{FF2B5EF4-FFF2-40B4-BE49-F238E27FC236}">
                <a16:creationId xmlns:a16="http://schemas.microsoft.com/office/drawing/2014/main" id="{DB6278C1-2729-B8E5-0C09-FC75690474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3613" y="3965504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2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30">
            <a:extLst>
              <a:ext uri="{FF2B5EF4-FFF2-40B4-BE49-F238E27FC236}">
                <a16:creationId xmlns:a16="http://schemas.microsoft.com/office/drawing/2014/main" id="{FDD57142-7B06-E409-1C9B-5C60B66333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3613" y="3117412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4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6" name="Rectangle 31">
            <a:extLst>
              <a:ext uri="{FF2B5EF4-FFF2-40B4-BE49-F238E27FC236}">
                <a16:creationId xmlns:a16="http://schemas.microsoft.com/office/drawing/2014/main" id="{52DCF5B7-C851-5C1F-18E8-13BD38347B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3613" y="2279113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6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32">
            <a:extLst>
              <a:ext uri="{FF2B5EF4-FFF2-40B4-BE49-F238E27FC236}">
                <a16:creationId xmlns:a16="http://schemas.microsoft.com/office/drawing/2014/main" id="{49DBF3CF-2758-72FE-34FC-15D59F5BC6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3613" y="1431021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8</a:t>
            </a:r>
            <a:endParaRPr kumimoji="0" lang="ja-JP" altLang="ja-JP" sz="3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33">
            <a:extLst>
              <a:ext uri="{FF2B5EF4-FFF2-40B4-BE49-F238E27FC236}">
                <a16:creationId xmlns:a16="http://schemas.microsoft.com/office/drawing/2014/main" id="{63722568-3F56-8A9C-32BB-3398C9EF0A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3613" y="592723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ja-JP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1.0</a:t>
            </a:r>
            <a:endParaRPr kumimoji="0" lang="ja-JP" altLang="ja-JP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Line 34">
            <a:extLst>
              <a:ext uri="{FF2B5EF4-FFF2-40B4-BE49-F238E27FC236}">
                <a16:creationId xmlns:a16="http://schemas.microsoft.com/office/drawing/2014/main" id="{C1738040-A61B-146D-8787-B10AB0CCF18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93894" y="481080"/>
            <a:ext cx="4553838" cy="4553842"/>
          </a:xfrm>
          <a:prstGeom prst="line">
            <a:avLst/>
          </a:prstGeom>
          <a:noFill/>
          <a:ln w="7938" cap="rnd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Freeform 35">
            <a:extLst>
              <a:ext uri="{FF2B5EF4-FFF2-40B4-BE49-F238E27FC236}">
                <a16:creationId xmlns:a16="http://schemas.microsoft.com/office/drawing/2014/main" id="{A4593D65-7379-AFD9-B761-5E1969A96F93}"/>
              </a:ext>
            </a:extLst>
          </p:cNvPr>
          <p:cNvSpPr>
            <a:spLocks/>
          </p:cNvSpPr>
          <p:nvPr/>
        </p:nvSpPr>
        <p:spPr bwMode="auto">
          <a:xfrm>
            <a:off x="2668213" y="647565"/>
            <a:ext cx="4213035" cy="4213039"/>
          </a:xfrm>
          <a:custGeom>
            <a:avLst/>
            <a:gdLst>
              <a:gd name="T0" fmla="*/ 457 w 457"/>
              <a:gd name="T1" fmla="*/ 0 h 457"/>
              <a:gd name="T2" fmla="*/ 151 w 457"/>
              <a:gd name="T3" fmla="*/ 96 h 457"/>
              <a:gd name="T4" fmla="*/ 0 w 457"/>
              <a:gd name="T5" fmla="*/ 457 h 4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7" h="457">
                <a:moveTo>
                  <a:pt x="457" y="0"/>
                </a:moveTo>
                <a:lnTo>
                  <a:pt x="151" y="96"/>
                </a:lnTo>
                <a:lnTo>
                  <a:pt x="0" y="457"/>
                </a:ln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Freeform 36">
            <a:extLst>
              <a:ext uri="{FF2B5EF4-FFF2-40B4-BE49-F238E27FC236}">
                <a16:creationId xmlns:a16="http://schemas.microsoft.com/office/drawing/2014/main" id="{A8FE9064-8DD3-C74B-1CD4-560888680AAB}"/>
              </a:ext>
            </a:extLst>
          </p:cNvPr>
          <p:cNvSpPr>
            <a:spLocks noEditPoints="1"/>
          </p:cNvSpPr>
          <p:nvPr/>
        </p:nvSpPr>
        <p:spPr bwMode="auto">
          <a:xfrm>
            <a:off x="2668213" y="657358"/>
            <a:ext cx="4140565" cy="4203245"/>
          </a:xfrm>
          <a:custGeom>
            <a:avLst/>
            <a:gdLst>
              <a:gd name="T0" fmla="*/ 441 w 449"/>
              <a:gd name="T1" fmla="*/ 2 h 456"/>
              <a:gd name="T2" fmla="*/ 425 w 449"/>
              <a:gd name="T3" fmla="*/ 4 h 456"/>
              <a:gd name="T4" fmla="*/ 409 w 449"/>
              <a:gd name="T5" fmla="*/ 7 h 456"/>
              <a:gd name="T6" fmla="*/ 393 w 449"/>
              <a:gd name="T7" fmla="*/ 10 h 456"/>
              <a:gd name="T8" fmla="*/ 377 w 449"/>
              <a:gd name="T9" fmla="*/ 13 h 456"/>
              <a:gd name="T10" fmla="*/ 361 w 449"/>
              <a:gd name="T11" fmla="*/ 15 h 456"/>
              <a:gd name="T12" fmla="*/ 345 w 449"/>
              <a:gd name="T13" fmla="*/ 18 h 456"/>
              <a:gd name="T14" fmla="*/ 329 w 449"/>
              <a:gd name="T15" fmla="*/ 21 h 456"/>
              <a:gd name="T16" fmla="*/ 313 w 449"/>
              <a:gd name="T17" fmla="*/ 24 h 456"/>
              <a:gd name="T18" fmla="*/ 297 w 449"/>
              <a:gd name="T19" fmla="*/ 26 h 456"/>
              <a:gd name="T20" fmla="*/ 281 w 449"/>
              <a:gd name="T21" fmla="*/ 29 h 456"/>
              <a:gd name="T22" fmla="*/ 265 w 449"/>
              <a:gd name="T23" fmla="*/ 32 h 456"/>
              <a:gd name="T24" fmla="*/ 249 w 449"/>
              <a:gd name="T25" fmla="*/ 35 h 456"/>
              <a:gd name="T26" fmla="*/ 233 w 449"/>
              <a:gd name="T27" fmla="*/ 37 h 456"/>
              <a:gd name="T28" fmla="*/ 217 w 449"/>
              <a:gd name="T29" fmla="*/ 40 h 456"/>
              <a:gd name="T30" fmla="*/ 201 w 449"/>
              <a:gd name="T31" fmla="*/ 43 h 456"/>
              <a:gd name="T32" fmla="*/ 185 w 449"/>
              <a:gd name="T33" fmla="*/ 46 h 456"/>
              <a:gd name="T34" fmla="*/ 177 w 449"/>
              <a:gd name="T35" fmla="*/ 47 h 456"/>
              <a:gd name="T36" fmla="*/ 169 w 449"/>
              <a:gd name="T37" fmla="*/ 61 h 456"/>
              <a:gd name="T38" fmla="*/ 161 w 449"/>
              <a:gd name="T39" fmla="*/ 76 h 456"/>
              <a:gd name="T40" fmla="*/ 153 w 449"/>
              <a:gd name="T41" fmla="*/ 91 h 456"/>
              <a:gd name="T42" fmla="*/ 146 w 449"/>
              <a:gd name="T43" fmla="*/ 107 h 456"/>
              <a:gd name="T44" fmla="*/ 139 w 449"/>
              <a:gd name="T45" fmla="*/ 122 h 456"/>
              <a:gd name="T46" fmla="*/ 132 w 449"/>
              <a:gd name="T47" fmla="*/ 138 h 456"/>
              <a:gd name="T48" fmla="*/ 125 w 449"/>
              <a:gd name="T49" fmla="*/ 153 h 456"/>
              <a:gd name="T50" fmla="*/ 117 w 449"/>
              <a:gd name="T51" fmla="*/ 169 h 456"/>
              <a:gd name="T52" fmla="*/ 110 w 449"/>
              <a:gd name="T53" fmla="*/ 185 h 456"/>
              <a:gd name="T54" fmla="*/ 103 w 449"/>
              <a:gd name="T55" fmla="*/ 200 h 456"/>
              <a:gd name="T56" fmla="*/ 96 w 449"/>
              <a:gd name="T57" fmla="*/ 216 h 456"/>
              <a:gd name="T58" fmla="*/ 89 w 449"/>
              <a:gd name="T59" fmla="*/ 231 h 456"/>
              <a:gd name="T60" fmla="*/ 82 w 449"/>
              <a:gd name="T61" fmla="*/ 247 h 456"/>
              <a:gd name="T62" fmla="*/ 75 w 449"/>
              <a:gd name="T63" fmla="*/ 262 h 456"/>
              <a:gd name="T64" fmla="*/ 68 w 449"/>
              <a:gd name="T65" fmla="*/ 278 h 456"/>
              <a:gd name="T66" fmla="*/ 61 w 449"/>
              <a:gd name="T67" fmla="*/ 294 h 456"/>
              <a:gd name="T68" fmla="*/ 54 w 449"/>
              <a:gd name="T69" fmla="*/ 310 h 456"/>
              <a:gd name="T70" fmla="*/ 47 w 449"/>
              <a:gd name="T71" fmla="*/ 325 h 456"/>
              <a:gd name="T72" fmla="*/ 40 w 449"/>
              <a:gd name="T73" fmla="*/ 341 h 456"/>
              <a:gd name="T74" fmla="*/ 33 w 449"/>
              <a:gd name="T75" fmla="*/ 356 h 456"/>
              <a:gd name="T76" fmla="*/ 26 w 449"/>
              <a:gd name="T77" fmla="*/ 371 h 456"/>
              <a:gd name="T78" fmla="*/ 24 w 449"/>
              <a:gd name="T79" fmla="*/ 379 h 456"/>
              <a:gd name="T80" fmla="*/ 19 w 449"/>
              <a:gd name="T81" fmla="*/ 395 h 456"/>
              <a:gd name="T82" fmla="*/ 14 w 449"/>
              <a:gd name="T83" fmla="*/ 411 h 456"/>
              <a:gd name="T84" fmla="*/ 9 w 449"/>
              <a:gd name="T85" fmla="*/ 427 h 456"/>
              <a:gd name="T86" fmla="*/ 4 w 449"/>
              <a:gd name="T87" fmla="*/ 443 h 4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449" h="456">
                <a:moveTo>
                  <a:pt x="441" y="2"/>
                </a:moveTo>
                <a:lnTo>
                  <a:pt x="433" y="3"/>
                </a:lnTo>
                <a:moveTo>
                  <a:pt x="425" y="4"/>
                </a:moveTo>
                <a:lnTo>
                  <a:pt x="417" y="6"/>
                </a:lnTo>
                <a:moveTo>
                  <a:pt x="409" y="7"/>
                </a:moveTo>
                <a:lnTo>
                  <a:pt x="401" y="9"/>
                </a:lnTo>
                <a:moveTo>
                  <a:pt x="393" y="10"/>
                </a:moveTo>
                <a:lnTo>
                  <a:pt x="385" y="11"/>
                </a:lnTo>
                <a:moveTo>
                  <a:pt x="377" y="13"/>
                </a:moveTo>
                <a:lnTo>
                  <a:pt x="369" y="14"/>
                </a:lnTo>
                <a:moveTo>
                  <a:pt x="361" y="15"/>
                </a:moveTo>
                <a:lnTo>
                  <a:pt x="353" y="17"/>
                </a:lnTo>
                <a:moveTo>
                  <a:pt x="345" y="18"/>
                </a:moveTo>
                <a:lnTo>
                  <a:pt x="337" y="20"/>
                </a:lnTo>
                <a:moveTo>
                  <a:pt x="329" y="21"/>
                </a:moveTo>
                <a:lnTo>
                  <a:pt x="321" y="22"/>
                </a:lnTo>
                <a:moveTo>
                  <a:pt x="313" y="24"/>
                </a:moveTo>
                <a:lnTo>
                  <a:pt x="305" y="25"/>
                </a:lnTo>
                <a:moveTo>
                  <a:pt x="297" y="26"/>
                </a:moveTo>
                <a:lnTo>
                  <a:pt x="289" y="28"/>
                </a:lnTo>
                <a:moveTo>
                  <a:pt x="281" y="29"/>
                </a:moveTo>
                <a:lnTo>
                  <a:pt x="273" y="31"/>
                </a:lnTo>
                <a:moveTo>
                  <a:pt x="265" y="32"/>
                </a:moveTo>
                <a:lnTo>
                  <a:pt x="257" y="33"/>
                </a:lnTo>
                <a:moveTo>
                  <a:pt x="249" y="35"/>
                </a:moveTo>
                <a:lnTo>
                  <a:pt x="241" y="36"/>
                </a:lnTo>
                <a:moveTo>
                  <a:pt x="233" y="37"/>
                </a:moveTo>
                <a:lnTo>
                  <a:pt x="225" y="39"/>
                </a:lnTo>
                <a:moveTo>
                  <a:pt x="217" y="40"/>
                </a:moveTo>
                <a:lnTo>
                  <a:pt x="209" y="42"/>
                </a:lnTo>
                <a:moveTo>
                  <a:pt x="201" y="43"/>
                </a:moveTo>
                <a:lnTo>
                  <a:pt x="193" y="44"/>
                </a:lnTo>
                <a:moveTo>
                  <a:pt x="185" y="46"/>
                </a:moveTo>
                <a:lnTo>
                  <a:pt x="177" y="47"/>
                </a:lnTo>
                <a:lnTo>
                  <a:pt x="177" y="47"/>
                </a:lnTo>
                <a:moveTo>
                  <a:pt x="173" y="54"/>
                </a:moveTo>
                <a:lnTo>
                  <a:pt x="169" y="61"/>
                </a:lnTo>
                <a:moveTo>
                  <a:pt x="165" y="69"/>
                </a:moveTo>
                <a:lnTo>
                  <a:pt x="161" y="76"/>
                </a:lnTo>
                <a:moveTo>
                  <a:pt x="157" y="84"/>
                </a:moveTo>
                <a:lnTo>
                  <a:pt x="153" y="91"/>
                </a:lnTo>
                <a:moveTo>
                  <a:pt x="149" y="99"/>
                </a:moveTo>
                <a:lnTo>
                  <a:pt x="146" y="107"/>
                </a:lnTo>
                <a:moveTo>
                  <a:pt x="142" y="114"/>
                </a:moveTo>
                <a:lnTo>
                  <a:pt x="139" y="122"/>
                </a:lnTo>
                <a:moveTo>
                  <a:pt x="135" y="130"/>
                </a:moveTo>
                <a:lnTo>
                  <a:pt x="132" y="138"/>
                </a:lnTo>
                <a:moveTo>
                  <a:pt x="128" y="145"/>
                </a:moveTo>
                <a:lnTo>
                  <a:pt x="125" y="153"/>
                </a:lnTo>
                <a:moveTo>
                  <a:pt x="121" y="161"/>
                </a:moveTo>
                <a:lnTo>
                  <a:pt x="117" y="169"/>
                </a:lnTo>
                <a:moveTo>
                  <a:pt x="114" y="177"/>
                </a:moveTo>
                <a:lnTo>
                  <a:pt x="110" y="185"/>
                </a:lnTo>
                <a:moveTo>
                  <a:pt x="107" y="193"/>
                </a:moveTo>
                <a:lnTo>
                  <a:pt x="103" y="200"/>
                </a:lnTo>
                <a:moveTo>
                  <a:pt x="100" y="208"/>
                </a:moveTo>
                <a:lnTo>
                  <a:pt x="96" y="216"/>
                </a:lnTo>
                <a:moveTo>
                  <a:pt x="93" y="224"/>
                </a:moveTo>
                <a:lnTo>
                  <a:pt x="89" y="231"/>
                </a:lnTo>
                <a:moveTo>
                  <a:pt x="86" y="239"/>
                </a:moveTo>
                <a:lnTo>
                  <a:pt x="82" y="247"/>
                </a:lnTo>
                <a:moveTo>
                  <a:pt x="79" y="255"/>
                </a:moveTo>
                <a:lnTo>
                  <a:pt x="75" y="262"/>
                </a:lnTo>
                <a:moveTo>
                  <a:pt x="72" y="270"/>
                </a:moveTo>
                <a:lnTo>
                  <a:pt x="68" y="278"/>
                </a:lnTo>
                <a:moveTo>
                  <a:pt x="64" y="286"/>
                </a:moveTo>
                <a:lnTo>
                  <a:pt x="61" y="294"/>
                </a:lnTo>
                <a:moveTo>
                  <a:pt x="57" y="302"/>
                </a:moveTo>
                <a:lnTo>
                  <a:pt x="54" y="310"/>
                </a:lnTo>
                <a:moveTo>
                  <a:pt x="50" y="317"/>
                </a:moveTo>
                <a:lnTo>
                  <a:pt x="47" y="325"/>
                </a:lnTo>
                <a:moveTo>
                  <a:pt x="43" y="333"/>
                </a:moveTo>
                <a:lnTo>
                  <a:pt x="40" y="341"/>
                </a:lnTo>
                <a:moveTo>
                  <a:pt x="36" y="348"/>
                </a:moveTo>
                <a:lnTo>
                  <a:pt x="33" y="356"/>
                </a:lnTo>
                <a:moveTo>
                  <a:pt x="29" y="364"/>
                </a:moveTo>
                <a:lnTo>
                  <a:pt x="26" y="371"/>
                </a:lnTo>
                <a:lnTo>
                  <a:pt x="26" y="371"/>
                </a:lnTo>
                <a:moveTo>
                  <a:pt x="24" y="379"/>
                </a:moveTo>
                <a:lnTo>
                  <a:pt x="21" y="387"/>
                </a:lnTo>
                <a:moveTo>
                  <a:pt x="19" y="395"/>
                </a:moveTo>
                <a:lnTo>
                  <a:pt x="16" y="403"/>
                </a:lnTo>
                <a:moveTo>
                  <a:pt x="14" y="411"/>
                </a:moveTo>
                <a:lnTo>
                  <a:pt x="11" y="419"/>
                </a:lnTo>
                <a:moveTo>
                  <a:pt x="9" y="427"/>
                </a:moveTo>
                <a:lnTo>
                  <a:pt x="6" y="435"/>
                </a:lnTo>
                <a:moveTo>
                  <a:pt x="4" y="443"/>
                </a:moveTo>
                <a:lnTo>
                  <a:pt x="2" y="451"/>
                </a:lnTo>
              </a:path>
            </a:pathLst>
          </a:custGeom>
          <a:noFill/>
          <a:ln w="57150" cap="rnd">
            <a:solidFill>
              <a:srgbClr val="000000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2" name="Line 37">
            <a:extLst>
              <a:ext uri="{FF2B5EF4-FFF2-40B4-BE49-F238E27FC236}">
                <a16:creationId xmlns:a16="http://schemas.microsoft.com/office/drawing/2014/main" id="{FFE65DBF-681C-6DA1-20A4-990759618742}"/>
              </a:ext>
            </a:extLst>
          </p:cNvPr>
          <p:cNvSpPr>
            <a:spLocks noChangeShapeType="1"/>
          </p:cNvSpPr>
          <p:nvPr/>
        </p:nvSpPr>
        <p:spPr bwMode="auto">
          <a:xfrm>
            <a:off x="4392754" y="3859429"/>
            <a:ext cx="256582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Freeform 38">
            <a:extLst>
              <a:ext uri="{FF2B5EF4-FFF2-40B4-BE49-F238E27FC236}">
                <a16:creationId xmlns:a16="http://schemas.microsoft.com/office/drawing/2014/main" id="{B7A7F01A-B498-80BC-FF52-08BCE8029EE2}"/>
              </a:ext>
            </a:extLst>
          </p:cNvPr>
          <p:cNvSpPr>
            <a:spLocks noEditPoints="1"/>
          </p:cNvSpPr>
          <p:nvPr/>
        </p:nvSpPr>
        <p:spPr bwMode="auto">
          <a:xfrm flipV="1">
            <a:off x="4325492" y="4074974"/>
            <a:ext cx="462417" cy="45719"/>
          </a:xfrm>
          <a:custGeom>
            <a:avLst/>
            <a:gdLst>
              <a:gd name="T0" fmla="*/ 0 w 24"/>
              <a:gd name="T1" fmla="*/ 4 w 24"/>
              <a:gd name="T2" fmla="*/ 8 w 24"/>
              <a:gd name="T3" fmla="*/ 12 w 24"/>
              <a:gd name="T4" fmla="*/ 16 w 24"/>
              <a:gd name="T5" fmla="*/ 20 w 24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4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</a:path>
            </a:pathLst>
          </a:custGeom>
          <a:noFill/>
          <a:ln w="38100" cap="rnd">
            <a:solidFill>
              <a:srgbClr val="000000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Rectangle 39">
            <a:extLst>
              <a:ext uri="{FF2B5EF4-FFF2-40B4-BE49-F238E27FC236}">
                <a16:creationId xmlns:a16="http://schemas.microsoft.com/office/drawing/2014/main" id="{A56F3668-CC13-6CD9-1F47-D9E18CCC6E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7497" y="3746089"/>
            <a:ext cx="20132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Model  1 : AUC=0.732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Freeform 36">
            <a:extLst>
              <a:ext uri="{FF2B5EF4-FFF2-40B4-BE49-F238E27FC236}">
                <a16:creationId xmlns:a16="http://schemas.microsoft.com/office/drawing/2014/main" id="{78061ACD-14E5-1527-6ABF-3D3C89A79D25}"/>
              </a:ext>
            </a:extLst>
          </p:cNvPr>
          <p:cNvSpPr>
            <a:spLocks noEditPoints="1"/>
          </p:cNvSpPr>
          <p:nvPr/>
        </p:nvSpPr>
        <p:spPr bwMode="auto">
          <a:xfrm>
            <a:off x="2667231" y="657357"/>
            <a:ext cx="4140564" cy="4150137"/>
          </a:xfrm>
          <a:custGeom>
            <a:avLst/>
            <a:gdLst>
              <a:gd name="T0" fmla="*/ 441 w 449"/>
              <a:gd name="T1" fmla="*/ 0 h 456"/>
              <a:gd name="T2" fmla="*/ 425 w 449"/>
              <a:gd name="T3" fmla="*/ 1 h 456"/>
              <a:gd name="T4" fmla="*/ 409 w 449"/>
              <a:gd name="T5" fmla="*/ 2 h 456"/>
              <a:gd name="T6" fmla="*/ 393 w 449"/>
              <a:gd name="T7" fmla="*/ 3 h 456"/>
              <a:gd name="T8" fmla="*/ 377 w 449"/>
              <a:gd name="T9" fmla="*/ 4 h 456"/>
              <a:gd name="T10" fmla="*/ 361 w 449"/>
              <a:gd name="T11" fmla="*/ 5 h 456"/>
              <a:gd name="T12" fmla="*/ 345 w 449"/>
              <a:gd name="T13" fmla="*/ 6 h 456"/>
              <a:gd name="T14" fmla="*/ 329 w 449"/>
              <a:gd name="T15" fmla="*/ 7 h 456"/>
              <a:gd name="T16" fmla="*/ 313 w 449"/>
              <a:gd name="T17" fmla="*/ 8 h 456"/>
              <a:gd name="T18" fmla="*/ 297 w 449"/>
              <a:gd name="T19" fmla="*/ 9 h 456"/>
              <a:gd name="T20" fmla="*/ 281 w 449"/>
              <a:gd name="T21" fmla="*/ 10 h 456"/>
              <a:gd name="T22" fmla="*/ 265 w 449"/>
              <a:gd name="T23" fmla="*/ 11 h 456"/>
              <a:gd name="T24" fmla="*/ 249 w 449"/>
              <a:gd name="T25" fmla="*/ 12 h 456"/>
              <a:gd name="T26" fmla="*/ 233 w 449"/>
              <a:gd name="T27" fmla="*/ 13 h 456"/>
              <a:gd name="T28" fmla="*/ 217 w 449"/>
              <a:gd name="T29" fmla="*/ 14 h 456"/>
              <a:gd name="T30" fmla="*/ 201 w 449"/>
              <a:gd name="T31" fmla="*/ 16 h 456"/>
              <a:gd name="T32" fmla="*/ 185 w 449"/>
              <a:gd name="T33" fmla="*/ 20 h 456"/>
              <a:gd name="T34" fmla="*/ 173 w 449"/>
              <a:gd name="T35" fmla="*/ 34 h 456"/>
              <a:gd name="T36" fmla="*/ 162 w 449"/>
              <a:gd name="T37" fmla="*/ 48 h 456"/>
              <a:gd name="T38" fmla="*/ 150 w 449"/>
              <a:gd name="T39" fmla="*/ 62 h 456"/>
              <a:gd name="T40" fmla="*/ 139 w 449"/>
              <a:gd name="T41" fmla="*/ 76 h 456"/>
              <a:gd name="T42" fmla="*/ 127 w 449"/>
              <a:gd name="T43" fmla="*/ 90 h 456"/>
              <a:gd name="T44" fmla="*/ 116 w 449"/>
              <a:gd name="T45" fmla="*/ 104 h 456"/>
              <a:gd name="T46" fmla="*/ 104 w 449"/>
              <a:gd name="T47" fmla="*/ 118 h 456"/>
              <a:gd name="T48" fmla="*/ 92 w 449"/>
              <a:gd name="T49" fmla="*/ 132 h 456"/>
              <a:gd name="T50" fmla="*/ 81 w 449"/>
              <a:gd name="T51" fmla="*/ 146 h 456"/>
              <a:gd name="T52" fmla="*/ 70 w 449"/>
              <a:gd name="T53" fmla="*/ 159 h 456"/>
              <a:gd name="T54" fmla="*/ 58 w 449"/>
              <a:gd name="T55" fmla="*/ 172 h 456"/>
              <a:gd name="T56" fmla="*/ 46 w 449"/>
              <a:gd name="T57" fmla="*/ 185 h 456"/>
              <a:gd name="T58" fmla="*/ 41 w 449"/>
              <a:gd name="T59" fmla="*/ 191 h 456"/>
              <a:gd name="T60" fmla="*/ 27 w 449"/>
              <a:gd name="T61" fmla="*/ 201 h 456"/>
              <a:gd name="T62" fmla="*/ 18 w 449"/>
              <a:gd name="T63" fmla="*/ 207 h 456"/>
              <a:gd name="T64" fmla="*/ 16 w 449"/>
              <a:gd name="T65" fmla="*/ 221 h 456"/>
              <a:gd name="T66" fmla="*/ 14 w 449"/>
              <a:gd name="T67" fmla="*/ 237 h 456"/>
              <a:gd name="T68" fmla="*/ 13 w 449"/>
              <a:gd name="T69" fmla="*/ 253 h 456"/>
              <a:gd name="T70" fmla="*/ 11 w 449"/>
              <a:gd name="T71" fmla="*/ 269 h 456"/>
              <a:gd name="T72" fmla="*/ 10 w 449"/>
              <a:gd name="T73" fmla="*/ 285 h 456"/>
              <a:gd name="T74" fmla="*/ 9 w 449"/>
              <a:gd name="T75" fmla="*/ 301 h 456"/>
              <a:gd name="T76" fmla="*/ 8 w 449"/>
              <a:gd name="T77" fmla="*/ 317 h 456"/>
              <a:gd name="T78" fmla="*/ 6 w 449"/>
              <a:gd name="T79" fmla="*/ 333 h 456"/>
              <a:gd name="T80" fmla="*/ 5 w 449"/>
              <a:gd name="T81" fmla="*/ 349 h 456"/>
              <a:gd name="T82" fmla="*/ 4 w 449"/>
              <a:gd name="T83" fmla="*/ 365 h 456"/>
              <a:gd name="T84" fmla="*/ 2 w 449"/>
              <a:gd name="T85" fmla="*/ 381 h 456"/>
              <a:gd name="T86" fmla="*/ 2 w 449"/>
              <a:gd name="T87" fmla="*/ 389 h 456"/>
              <a:gd name="T88" fmla="*/ 1 w 449"/>
              <a:gd name="T89" fmla="*/ 405 h 456"/>
              <a:gd name="T90" fmla="*/ 1 w 449"/>
              <a:gd name="T91" fmla="*/ 421 h 456"/>
              <a:gd name="T92" fmla="*/ 1 w 449"/>
              <a:gd name="T93" fmla="*/ 437 h 456"/>
              <a:gd name="T94" fmla="*/ 0 w 449"/>
              <a:gd name="T95" fmla="*/ 453 h 4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449" h="456">
                <a:moveTo>
                  <a:pt x="441" y="0"/>
                </a:moveTo>
                <a:lnTo>
                  <a:pt x="433" y="1"/>
                </a:lnTo>
                <a:moveTo>
                  <a:pt x="425" y="1"/>
                </a:moveTo>
                <a:lnTo>
                  <a:pt x="417" y="2"/>
                </a:lnTo>
                <a:moveTo>
                  <a:pt x="409" y="2"/>
                </a:moveTo>
                <a:lnTo>
                  <a:pt x="401" y="3"/>
                </a:lnTo>
                <a:moveTo>
                  <a:pt x="393" y="3"/>
                </a:moveTo>
                <a:lnTo>
                  <a:pt x="385" y="4"/>
                </a:lnTo>
                <a:moveTo>
                  <a:pt x="377" y="4"/>
                </a:moveTo>
                <a:lnTo>
                  <a:pt x="369" y="5"/>
                </a:lnTo>
                <a:moveTo>
                  <a:pt x="361" y="5"/>
                </a:moveTo>
                <a:lnTo>
                  <a:pt x="353" y="6"/>
                </a:lnTo>
                <a:moveTo>
                  <a:pt x="345" y="6"/>
                </a:moveTo>
                <a:lnTo>
                  <a:pt x="337" y="7"/>
                </a:lnTo>
                <a:moveTo>
                  <a:pt x="329" y="7"/>
                </a:moveTo>
                <a:lnTo>
                  <a:pt x="321" y="8"/>
                </a:lnTo>
                <a:moveTo>
                  <a:pt x="313" y="8"/>
                </a:moveTo>
                <a:lnTo>
                  <a:pt x="305" y="9"/>
                </a:lnTo>
                <a:moveTo>
                  <a:pt x="297" y="9"/>
                </a:moveTo>
                <a:lnTo>
                  <a:pt x="289" y="10"/>
                </a:lnTo>
                <a:moveTo>
                  <a:pt x="281" y="10"/>
                </a:moveTo>
                <a:lnTo>
                  <a:pt x="273" y="11"/>
                </a:lnTo>
                <a:moveTo>
                  <a:pt x="265" y="11"/>
                </a:moveTo>
                <a:lnTo>
                  <a:pt x="257" y="12"/>
                </a:lnTo>
                <a:moveTo>
                  <a:pt x="249" y="12"/>
                </a:moveTo>
                <a:lnTo>
                  <a:pt x="241" y="13"/>
                </a:lnTo>
                <a:moveTo>
                  <a:pt x="233" y="13"/>
                </a:moveTo>
                <a:lnTo>
                  <a:pt x="225" y="14"/>
                </a:lnTo>
                <a:moveTo>
                  <a:pt x="217" y="14"/>
                </a:moveTo>
                <a:lnTo>
                  <a:pt x="209" y="15"/>
                </a:lnTo>
                <a:moveTo>
                  <a:pt x="201" y="16"/>
                </a:moveTo>
                <a:lnTo>
                  <a:pt x="193" y="18"/>
                </a:lnTo>
                <a:moveTo>
                  <a:pt x="185" y="20"/>
                </a:moveTo>
                <a:lnTo>
                  <a:pt x="179" y="27"/>
                </a:lnTo>
                <a:moveTo>
                  <a:pt x="173" y="34"/>
                </a:moveTo>
                <a:lnTo>
                  <a:pt x="168" y="41"/>
                </a:lnTo>
                <a:moveTo>
                  <a:pt x="162" y="48"/>
                </a:moveTo>
                <a:lnTo>
                  <a:pt x="156" y="55"/>
                </a:lnTo>
                <a:moveTo>
                  <a:pt x="150" y="62"/>
                </a:moveTo>
                <a:lnTo>
                  <a:pt x="144" y="69"/>
                </a:lnTo>
                <a:moveTo>
                  <a:pt x="139" y="76"/>
                </a:moveTo>
                <a:lnTo>
                  <a:pt x="133" y="83"/>
                </a:lnTo>
                <a:moveTo>
                  <a:pt x="127" y="90"/>
                </a:moveTo>
                <a:lnTo>
                  <a:pt x="121" y="97"/>
                </a:lnTo>
                <a:moveTo>
                  <a:pt x="116" y="104"/>
                </a:moveTo>
                <a:lnTo>
                  <a:pt x="110" y="111"/>
                </a:lnTo>
                <a:moveTo>
                  <a:pt x="104" y="118"/>
                </a:moveTo>
                <a:lnTo>
                  <a:pt x="98" y="125"/>
                </a:lnTo>
                <a:moveTo>
                  <a:pt x="92" y="132"/>
                </a:moveTo>
                <a:lnTo>
                  <a:pt x="87" y="139"/>
                </a:lnTo>
                <a:moveTo>
                  <a:pt x="81" y="146"/>
                </a:moveTo>
                <a:lnTo>
                  <a:pt x="75" y="153"/>
                </a:lnTo>
                <a:moveTo>
                  <a:pt x="70" y="159"/>
                </a:moveTo>
                <a:lnTo>
                  <a:pt x="64" y="166"/>
                </a:lnTo>
                <a:moveTo>
                  <a:pt x="58" y="172"/>
                </a:moveTo>
                <a:lnTo>
                  <a:pt x="52" y="179"/>
                </a:lnTo>
                <a:moveTo>
                  <a:pt x="46" y="185"/>
                </a:moveTo>
                <a:lnTo>
                  <a:pt x="41" y="191"/>
                </a:lnTo>
                <a:lnTo>
                  <a:pt x="41" y="191"/>
                </a:lnTo>
                <a:moveTo>
                  <a:pt x="34" y="196"/>
                </a:moveTo>
                <a:lnTo>
                  <a:pt x="27" y="201"/>
                </a:lnTo>
                <a:moveTo>
                  <a:pt x="20" y="206"/>
                </a:moveTo>
                <a:lnTo>
                  <a:pt x="18" y="207"/>
                </a:lnTo>
                <a:lnTo>
                  <a:pt x="17" y="213"/>
                </a:lnTo>
                <a:moveTo>
                  <a:pt x="16" y="221"/>
                </a:moveTo>
                <a:lnTo>
                  <a:pt x="15" y="229"/>
                </a:lnTo>
                <a:moveTo>
                  <a:pt x="14" y="237"/>
                </a:moveTo>
                <a:lnTo>
                  <a:pt x="13" y="245"/>
                </a:lnTo>
                <a:moveTo>
                  <a:pt x="13" y="253"/>
                </a:moveTo>
                <a:lnTo>
                  <a:pt x="12" y="261"/>
                </a:lnTo>
                <a:moveTo>
                  <a:pt x="11" y="269"/>
                </a:moveTo>
                <a:lnTo>
                  <a:pt x="11" y="277"/>
                </a:lnTo>
                <a:moveTo>
                  <a:pt x="10" y="285"/>
                </a:moveTo>
                <a:lnTo>
                  <a:pt x="9" y="293"/>
                </a:lnTo>
                <a:moveTo>
                  <a:pt x="9" y="301"/>
                </a:moveTo>
                <a:lnTo>
                  <a:pt x="8" y="309"/>
                </a:lnTo>
                <a:moveTo>
                  <a:pt x="8" y="317"/>
                </a:moveTo>
                <a:lnTo>
                  <a:pt x="7" y="325"/>
                </a:lnTo>
                <a:moveTo>
                  <a:pt x="6" y="333"/>
                </a:moveTo>
                <a:lnTo>
                  <a:pt x="6" y="341"/>
                </a:lnTo>
                <a:moveTo>
                  <a:pt x="5" y="349"/>
                </a:moveTo>
                <a:lnTo>
                  <a:pt x="4" y="357"/>
                </a:lnTo>
                <a:moveTo>
                  <a:pt x="4" y="365"/>
                </a:moveTo>
                <a:lnTo>
                  <a:pt x="3" y="373"/>
                </a:lnTo>
                <a:moveTo>
                  <a:pt x="2" y="381"/>
                </a:moveTo>
                <a:lnTo>
                  <a:pt x="2" y="387"/>
                </a:lnTo>
                <a:lnTo>
                  <a:pt x="2" y="389"/>
                </a:lnTo>
                <a:moveTo>
                  <a:pt x="2" y="397"/>
                </a:moveTo>
                <a:lnTo>
                  <a:pt x="1" y="405"/>
                </a:lnTo>
                <a:moveTo>
                  <a:pt x="1" y="413"/>
                </a:moveTo>
                <a:lnTo>
                  <a:pt x="1" y="421"/>
                </a:lnTo>
                <a:moveTo>
                  <a:pt x="1" y="429"/>
                </a:moveTo>
                <a:lnTo>
                  <a:pt x="1" y="437"/>
                </a:lnTo>
                <a:moveTo>
                  <a:pt x="0" y="445"/>
                </a:moveTo>
                <a:lnTo>
                  <a:pt x="0" y="453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Line 37">
            <a:extLst>
              <a:ext uri="{FF2B5EF4-FFF2-40B4-BE49-F238E27FC236}">
                <a16:creationId xmlns:a16="http://schemas.microsoft.com/office/drawing/2014/main" id="{E7AC8CC7-1404-5915-B48F-CBAE40F4DC14}"/>
              </a:ext>
            </a:extLst>
          </p:cNvPr>
          <p:cNvSpPr>
            <a:spLocks noChangeShapeType="1"/>
          </p:cNvSpPr>
          <p:nvPr/>
        </p:nvSpPr>
        <p:spPr bwMode="auto">
          <a:xfrm>
            <a:off x="4382594" y="4396581"/>
            <a:ext cx="256582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" name="タイトル 3">
            <a:extLst>
              <a:ext uri="{FF2B5EF4-FFF2-40B4-BE49-F238E27FC236}">
                <a16:creationId xmlns:a16="http://schemas.microsoft.com/office/drawing/2014/main" id="{ED3172C6-F39A-7E44-79C1-A9E1C45599E2}"/>
              </a:ext>
            </a:extLst>
          </p:cNvPr>
          <p:cNvSpPr txBox="1">
            <a:spLocks/>
          </p:cNvSpPr>
          <p:nvPr/>
        </p:nvSpPr>
        <p:spPr>
          <a:xfrm>
            <a:off x="0" y="6194498"/>
            <a:ext cx="9144000" cy="605631"/>
          </a:xfrm>
          <a:prstGeom prst="rect">
            <a:avLst/>
          </a:prstGeom>
        </p:spPr>
        <p:txBody>
          <a:bodyPr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6858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F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gure</a:t>
            </a:r>
            <a:r>
              <a:rPr lang="ja-JP" altLang="en-US" sz="2000" dirty="0">
                <a:solidFill>
                  <a:prstClr val="black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solidFill>
                  <a:prstClr val="black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ROC curves for each simplified frailty assessment model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E733FAC-13DA-9CDA-00BF-548F5C15C194}"/>
              </a:ext>
            </a:extLst>
          </p:cNvPr>
          <p:cNvSpPr txBox="1"/>
          <p:nvPr/>
        </p:nvSpPr>
        <p:spPr>
          <a:xfrm>
            <a:off x="127431" y="5719326"/>
            <a:ext cx="890179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ctr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he variables for each model are as follows.</a:t>
            </a:r>
          </a:p>
          <a:p>
            <a:pPr marL="0" marR="0" lvl="0" indent="0" algn="l" defTabSz="914400" rtl="0" eaLnBrk="1" fontAlgn="ctr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odel 1: slowness     Model 2: slowness, hypoalbuminemia   Model 3: slowness, hypoalbuminemia, weakness</a:t>
            </a:r>
            <a:endParaRPr kumimoji="1" lang="ja-JP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5" name="Rectangle 39">
            <a:extLst>
              <a:ext uri="{FF2B5EF4-FFF2-40B4-BE49-F238E27FC236}">
                <a16:creationId xmlns:a16="http://schemas.microsoft.com/office/drawing/2014/main" id="{EB1CD6A5-9D4D-F7EB-00B8-3B97303135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7657" y="4010249"/>
            <a:ext cx="20132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Model  2 : AUC=0.769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7" name="Rectangle 39">
            <a:extLst>
              <a:ext uri="{FF2B5EF4-FFF2-40B4-BE49-F238E27FC236}">
                <a16:creationId xmlns:a16="http://schemas.microsoft.com/office/drawing/2014/main" id="{794F8FF2-79D7-35E4-5B79-4F10A2F13E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7657" y="4274409"/>
            <a:ext cx="20132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Model  3 : AUC=0.868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3998351"/>
      </p:ext>
    </p:extLst>
  </p:cSld>
  <p:clrMapOvr>
    <a:masterClrMapping/>
  </p:clrMapOvr>
</p:sld>
</file>

<file path=ppt/theme/theme1.xml><?xml version="1.0" encoding="utf-8"?>
<a:theme xmlns:a="http://schemas.openxmlformats.org/drawingml/2006/main" name="HDOfficeLightV0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53</TotalTime>
  <Words>1709</Words>
  <Application>Microsoft Office PowerPoint</Application>
  <PresentationFormat>画面に合わせる (4:3)</PresentationFormat>
  <Paragraphs>459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6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Wingdings 2</vt:lpstr>
      <vt:lpstr>HDOfficeLightV0</vt:lpstr>
      <vt:lpstr>Office 2013 - 2022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モデルマウスを用いた レビー小体型認知症の 新規バイオマーカーの探索</dc:title>
  <dc:creator>小林 啓</dc:creator>
  <cp:lastModifiedBy>祐 本多</cp:lastModifiedBy>
  <cp:revision>27</cp:revision>
  <cp:lastPrinted>2025-05-25T00:34:36Z</cp:lastPrinted>
  <dcterms:created xsi:type="dcterms:W3CDTF">2021-10-03T08:53:19Z</dcterms:created>
  <dcterms:modified xsi:type="dcterms:W3CDTF">2025-09-26T08:20:33Z</dcterms:modified>
</cp:coreProperties>
</file>